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7"/>
  </p:notesMasterIdLst>
  <p:sldIdLst>
    <p:sldId id="337" r:id="rId2"/>
    <p:sldId id="343" r:id="rId3"/>
    <p:sldId id="338" r:id="rId4"/>
    <p:sldId id="346" r:id="rId5"/>
    <p:sldId id="339" r:id="rId6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05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028"/>
    <p:restoredTop sz="94626"/>
  </p:normalViewPr>
  <p:slideViewPr>
    <p:cSldViewPr snapToObjects="1">
      <p:cViewPr varScale="1">
        <p:scale>
          <a:sx n="116" d="100"/>
          <a:sy n="116" d="100"/>
        </p:scale>
        <p:origin x="2112" y="192"/>
      </p:cViewPr>
      <p:guideLst>
        <p:guide orient="horz" pos="2160"/>
        <p:guide pos="305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SSD&#65298;T/Dropbox/Dropbox/&#31119;&#21407;&#20849;&#26377;&#29992;/&#34880;&#28479;&#39620;&#28082;osimertinib/&#32080;&#26524;/&#28611;&#24230;&#35430;&#39443;CRF&#12486;&#12441;&#12540;&#12479;v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fukuharatatsurou/Dropbox/&#31119;&#21407;&#20849;&#26377;&#29992;/&#12458;&#12471;&#12513;&#12523;&#12481;&#12491;&#12501;&#12441;&#28611;&#24230;&#35430;&#39443;/&#32080;&#26524;/&#28611;&#24230;&#35430;&#39443;CRF&#12486;&#12441;&#12540;&#12479;v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SSD2T/Dropbox/&#31119;&#21407;&#20849;&#26377;&#29992;/&#12458;&#12471;&#12513;&#12523;&#12481;&#12491;&#12501;&#12441;&#28611;&#24230;&#35430;&#39443;/&#32080;&#26524;/&#28611;&#24230;&#35430;&#39443;CRF&#12486;&#12441;&#12540;&#12479;v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SSD2T/Dropbox/&#31119;&#21407;&#20849;&#26377;&#29992;/&#12458;&#12471;&#12513;&#12523;&#12481;&#12491;&#12501;&#12441;&#28611;&#24230;&#35430;&#39443;/&#32080;&#26524;/&#28611;&#24230;&#35430;&#39443;CRF&#12486;&#12441;&#12540;&#12479;v2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副作用!$R$52:$AD$52</c:f>
              <c:strCache>
                <c:ptCount val="13"/>
                <c:pt idx="0">
                  <c:v>肺臓炎</c:v>
                </c:pt>
                <c:pt idx="1">
                  <c:v>QT延長</c:v>
                </c:pt>
                <c:pt idx="2">
                  <c:v>好中球減少</c:v>
                </c:pt>
                <c:pt idx="3">
                  <c:v>肝障害</c:v>
                </c:pt>
                <c:pt idx="4">
                  <c:v>白血球減少</c:v>
                </c:pt>
                <c:pt idx="5">
                  <c:v>皮疹</c:v>
                </c:pt>
                <c:pt idx="6">
                  <c:v>爪囲炎</c:v>
                </c:pt>
                <c:pt idx="7">
                  <c:v>悪心</c:v>
                </c:pt>
                <c:pt idx="8">
                  <c:v>嘔吐</c:v>
                </c:pt>
                <c:pt idx="9">
                  <c:v>食欲不振</c:v>
                </c:pt>
                <c:pt idx="10">
                  <c:v>下痢</c:v>
                </c:pt>
                <c:pt idx="11">
                  <c:v>血小板減少</c:v>
                </c:pt>
                <c:pt idx="12">
                  <c:v>貧血</c:v>
                </c:pt>
              </c:strCache>
            </c:strRef>
          </c:cat>
          <c:val>
            <c:numRef>
              <c:f>副作用!$R$53:$AD$53</c:f>
              <c:numCache>
                <c:formatCode>0.0_ </c:formatCode>
                <c:ptCount val="13"/>
                <c:pt idx="0">
                  <c:v>19.512195121951219</c:v>
                </c:pt>
                <c:pt idx="1">
                  <c:v>4.8780487804878048</c:v>
                </c:pt>
                <c:pt idx="2">
                  <c:v>14.634146341463413</c:v>
                </c:pt>
                <c:pt idx="3">
                  <c:v>14.634146341463413</c:v>
                </c:pt>
                <c:pt idx="4">
                  <c:v>14.634146341463413</c:v>
                </c:pt>
                <c:pt idx="5">
                  <c:v>36.585365853658537</c:v>
                </c:pt>
                <c:pt idx="6">
                  <c:v>24.390243902439025</c:v>
                </c:pt>
                <c:pt idx="7">
                  <c:v>17.073170731707318</c:v>
                </c:pt>
                <c:pt idx="8">
                  <c:v>17.073170731707318</c:v>
                </c:pt>
                <c:pt idx="9">
                  <c:v>31.707317073170731</c:v>
                </c:pt>
                <c:pt idx="10">
                  <c:v>26.829268292682929</c:v>
                </c:pt>
                <c:pt idx="11">
                  <c:v>29.268292682926827</c:v>
                </c:pt>
                <c:pt idx="12">
                  <c:v>29.2682926829268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D50-CC45-A024-05F97BE4DF1F}"/>
            </c:ext>
          </c:extLst>
        </c:ser>
        <c:ser>
          <c:idx val="1"/>
          <c:order val="1"/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副作用!$R$52:$AD$52</c:f>
              <c:strCache>
                <c:ptCount val="13"/>
                <c:pt idx="0">
                  <c:v>肺臓炎</c:v>
                </c:pt>
                <c:pt idx="1">
                  <c:v>QT延長</c:v>
                </c:pt>
                <c:pt idx="2">
                  <c:v>好中球減少</c:v>
                </c:pt>
                <c:pt idx="3">
                  <c:v>肝障害</c:v>
                </c:pt>
                <c:pt idx="4">
                  <c:v>白血球減少</c:v>
                </c:pt>
                <c:pt idx="5">
                  <c:v>皮疹</c:v>
                </c:pt>
                <c:pt idx="6">
                  <c:v>爪囲炎</c:v>
                </c:pt>
                <c:pt idx="7">
                  <c:v>悪心</c:v>
                </c:pt>
                <c:pt idx="8">
                  <c:v>嘔吐</c:v>
                </c:pt>
                <c:pt idx="9">
                  <c:v>食欲不振</c:v>
                </c:pt>
                <c:pt idx="10">
                  <c:v>下痢</c:v>
                </c:pt>
                <c:pt idx="11">
                  <c:v>血小板減少</c:v>
                </c:pt>
                <c:pt idx="12">
                  <c:v>貧血</c:v>
                </c:pt>
              </c:strCache>
            </c:strRef>
          </c:cat>
          <c:val>
            <c:numRef>
              <c:f>副作用!$R$54:$AD$54</c:f>
              <c:numCache>
                <c:formatCode>0.0_ </c:formatCode>
                <c:ptCount val="13"/>
                <c:pt idx="0">
                  <c:v>2.4390243902439024</c:v>
                </c:pt>
                <c:pt idx="1">
                  <c:v>2.4390243902439024</c:v>
                </c:pt>
                <c:pt idx="2">
                  <c:v>2.4390243902439024</c:v>
                </c:pt>
                <c:pt idx="3">
                  <c:v>2.4390243902439024</c:v>
                </c:pt>
                <c:pt idx="4">
                  <c:v>2.4390243902439024</c:v>
                </c:pt>
                <c:pt idx="5">
                  <c:v>2.4390243902439024</c:v>
                </c:pt>
                <c:pt idx="6">
                  <c:v>0</c:v>
                </c:pt>
                <c:pt idx="7">
                  <c:v>7.3170731707317067</c:v>
                </c:pt>
                <c:pt idx="8">
                  <c:v>9.7560975609756095</c:v>
                </c:pt>
                <c:pt idx="9">
                  <c:v>9.7560975609756095</c:v>
                </c:pt>
                <c:pt idx="10">
                  <c:v>4.8780487804878048</c:v>
                </c:pt>
                <c:pt idx="11">
                  <c:v>0</c:v>
                </c:pt>
                <c:pt idx="12">
                  <c:v>2.43902439024390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D50-CC45-A024-05F97BE4DF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427315391"/>
        <c:axId val="427317023"/>
      </c:barChart>
      <c:catAx>
        <c:axId val="427315391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GMaruGothicMPRO" panose="020F0600000000000000" pitchFamily="34" charset="-128"/>
                <a:ea typeface="HGMaruGothicMPRO" panose="020F0600000000000000" pitchFamily="34" charset="-128"/>
                <a:cs typeface="+mn-cs"/>
              </a:defRPr>
            </a:pPr>
            <a:endParaRPr lang="ja-JP"/>
          </a:p>
        </c:txPr>
        <c:crossAx val="427317023"/>
        <c:crosses val="autoZero"/>
        <c:auto val="1"/>
        <c:lblAlgn val="ctr"/>
        <c:lblOffset val="100"/>
        <c:noMultiLvlLbl val="0"/>
      </c:catAx>
      <c:valAx>
        <c:axId val="427317023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_ 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7315391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1"/>
          <c:order val="0"/>
          <c:tx>
            <c:strRef>
              <c:f>BSA関連!$J$1</c:f>
              <c:strCache>
                <c:ptCount val="1"/>
                <c:pt idx="0">
                  <c:v>登録番号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2"/>
                </a:solidFill>
                <a:prstDash val="sysDot"/>
              </a:ln>
              <a:effectLst/>
            </c:spPr>
            <c:trendlineType val="linear"/>
            <c:forward val="2"/>
            <c:dispRSqr val="0"/>
            <c:dispEq val="1"/>
            <c:trendlineLbl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BSA関連!$L$3:$L$45</c:f>
              <c:numCache>
                <c:formatCode>General</c:formatCode>
                <c:ptCount val="43"/>
                <c:pt idx="0">
                  <c:v>1.4851162545790852</c:v>
                </c:pt>
                <c:pt idx="1">
                  <c:v>1.5065418917860687</c:v>
                </c:pt>
                <c:pt idx="2">
                  <c:v>1.5539412870016649</c:v>
                </c:pt>
                <c:pt idx="3">
                  <c:v>1.4251299742131225</c:v>
                </c:pt>
                <c:pt idx="4">
                  <c:v>1.9561110781032505</c:v>
                </c:pt>
                <c:pt idx="5">
                  <c:v>1.4999610607268181</c:v>
                </c:pt>
                <c:pt idx="6">
                  <c:v>1.4981032273147941</c:v>
                </c:pt>
                <c:pt idx="7">
                  <c:v>1.4969082852587234</c:v>
                </c:pt>
                <c:pt idx="8">
                  <c:v>1.7187323830585415</c:v>
                </c:pt>
                <c:pt idx="9">
                  <c:v>1.6249486828522055</c:v>
                </c:pt>
                <c:pt idx="10">
                  <c:v>1.4423890479946124</c:v>
                </c:pt>
                <c:pt idx="11">
                  <c:v>1.2990827309515574</c:v>
                </c:pt>
                <c:pt idx="12">
                  <c:v>1.447955922156932</c:v>
                </c:pt>
                <c:pt idx="13">
                  <c:v>1.7260563573488634</c:v>
                </c:pt>
                <c:pt idx="14">
                  <c:v>1.3530158967960011</c:v>
                </c:pt>
                <c:pt idx="15">
                  <c:v>1.3423120485654105</c:v>
                </c:pt>
                <c:pt idx="16">
                  <c:v>1.3246231153137085</c:v>
                </c:pt>
                <c:pt idx="17">
                  <c:v>1.806800269733905</c:v>
                </c:pt>
                <c:pt idx="18">
                  <c:v>1.7261597954709254</c:v>
                </c:pt>
                <c:pt idx="19">
                  <c:v>1.6388306532463586</c:v>
                </c:pt>
                <c:pt idx="20">
                  <c:v>1.5309738951956291</c:v>
                </c:pt>
                <c:pt idx="21">
                  <c:v>0</c:v>
                </c:pt>
                <c:pt idx="22">
                  <c:v>0</c:v>
                </c:pt>
                <c:pt idx="23">
                  <c:v>1.8196245028202944</c:v>
                </c:pt>
                <c:pt idx="24">
                  <c:v>1.7541882743623156</c:v>
                </c:pt>
                <c:pt idx="25">
                  <c:v>1.3634442677610243</c:v>
                </c:pt>
                <c:pt idx="26">
                  <c:v>1.7470483616447858</c:v>
                </c:pt>
                <c:pt idx="27">
                  <c:v>1.4221992192510087</c:v>
                </c:pt>
                <c:pt idx="28">
                  <c:v>1.2764276589041867</c:v>
                </c:pt>
                <c:pt idx="29">
                  <c:v>1.2548535845366267</c:v>
                </c:pt>
                <c:pt idx="30">
                  <c:v>1.2974238938914027</c:v>
                </c:pt>
                <c:pt idx="31">
                  <c:v>1.593080776203786</c:v>
                </c:pt>
                <c:pt idx="32">
                  <c:v>1.2721406204462811</c:v>
                </c:pt>
                <c:pt idx="33">
                  <c:v>1.2945309404437118</c:v>
                </c:pt>
                <c:pt idx="34">
                  <c:v>1.5542215816479299</c:v>
                </c:pt>
                <c:pt idx="35">
                  <c:v>1.2705324275933723</c:v>
                </c:pt>
                <c:pt idx="36">
                  <c:v>1.772911278229929</c:v>
                </c:pt>
                <c:pt idx="37">
                  <c:v>1.4086099183428895</c:v>
                </c:pt>
                <c:pt idx="38">
                  <c:v>1.3829434429745886</c:v>
                </c:pt>
                <c:pt idx="39">
                  <c:v>1.2914377078311643</c:v>
                </c:pt>
                <c:pt idx="40">
                  <c:v>1.4309889473473025</c:v>
                </c:pt>
                <c:pt idx="41">
                  <c:v>1.6960437007774207</c:v>
                </c:pt>
                <c:pt idx="42">
                  <c:v>1.4325003551708724</c:v>
                </c:pt>
              </c:numCache>
            </c:numRef>
          </c:xVal>
          <c:yVal>
            <c:numRef>
              <c:f>BSA関連!$K$3:$K$45</c:f>
              <c:numCache>
                <c:formatCode>General</c:formatCode>
                <c:ptCount val="43"/>
                <c:pt idx="0">
                  <c:v>187</c:v>
                </c:pt>
                <c:pt idx="1">
                  <c:v>186</c:v>
                </c:pt>
                <c:pt idx="2" formatCode="@">
                  <c:v>0</c:v>
                </c:pt>
                <c:pt idx="3">
                  <c:v>564</c:v>
                </c:pt>
                <c:pt idx="4">
                  <c:v>157</c:v>
                </c:pt>
                <c:pt idx="5">
                  <c:v>730</c:v>
                </c:pt>
                <c:pt idx="6">
                  <c:v>251</c:v>
                </c:pt>
                <c:pt idx="8">
                  <c:v>266</c:v>
                </c:pt>
                <c:pt idx="10">
                  <c:v>402</c:v>
                </c:pt>
                <c:pt idx="11">
                  <c:v>477</c:v>
                </c:pt>
                <c:pt idx="12">
                  <c:v>375</c:v>
                </c:pt>
                <c:pt idx="13">
                  <c:v>156</c:v>
                </c:pt>
                <c:pt idx="14">
                  <c:v>131</c:v>
                </c:pt>
                <c:pt idx="15">
                  <c:v>368</c:v>
                </c:pt>
                <c:pt idx="16">
                  <c:v>508</c:v>
                </c:pt>
                <c:pt idx="17">
                  <c:v>165</c:v>
                </c:pt>
                <c:pt idx="18">
                  <c:v>176</c:v>
                </c:pt>
                <c:pt idx="19">
                  <c:v>149</c:v>
                </c:pt>
                <c:pt idx="20">
                  <c:v>848</c:v>
                </c:pt>
                <c:pt idx="23">
                  <c:v>164</c:v>
                </c:pt>
                <c:pt idx="24">
                  <c:v>334</c:v>
                </c:pt>
                <c:pt idx="25">
                  <c:v>123</c:v>
                </c:pt>
                <c:pt idx="26">
                  <c:v>235</c:v>
                </c:pt>
                <c:pt idx="27">
                  <c:v>372</c:v>
                </c:pt>
                <c:pt idx="28">
                  <c:v>283</c:v>
                </c:pt>
                <c:pt idx="29">
                  <c:v>216</c:v>
                </c:pt>
                <c:pt idx="30">
                  <c:v>161</c:v>
                </c:pt>
                <c:pt idx="31">
                  <c:v>69.7</c:v>
                </c:pt>
                <c:pt idx="32">
                  <c:v>339</c:v>
                </c:pt>
                <c:pt idx="33">
                  <c:v>227</c:v>
                </c:pt>
                <c:pt idx="34">
                  <c:v>90.6</c:v>
                </c:pt>
                <c:pt idx="35">
                  <c:v>136</c:v>
                </c:pt>
                <c:pt idx="36">
                  <c:v>209</c:v>
                </c:pt>
                <c:pt idx="37">
                  <c:v>276</c:v>
                </c:pt>
                <c:pt idx="38">
                  <c:v>260</c:v>
                </c:pt>
                <c:pt idx="39">
                  <c:v>198</c:v>
                </c:pt>
                <c:pt idx="40">
                  <c:v>335</c:v>
                </c:pt>
                <c:pt idx="42">
                  <c:v>17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F58-E14F-B7AA-41BD13E896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32494847"/>
        <c:axId val="1032496527"/>
      </c:scatterChart>
      <c:valAx>
        <c:axId val="1032494847"/>
        <c:scaling>
          <c:orientation val="minMax"/>
          <c:max val="2"/>
          <c:min val="1.2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32496527"/>
        <c:crosses val="autoZero"/>
        <c:crossBetween val="midCat"/>
      </c:valAx>
      <c:valAx>
        <c:axId val="1032496527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32494847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1"/>
          <c:order val="0"/>
          <c:tx>
            <c:strRef>
              <c:f>BMIとP1!$J$1</c:f>
              <c:strCache>
                <c:ptCount val="1"/>
                <c:pt idx="0">
                  <c:v>登録番号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2"/>
                </a:solidFill>
                <a:prstDash val="sysDot"/>
              </a:ln>
              <a:effectLst/>
            </c:spPr>
            <c:trendlineType val="linear"/>
            <c:forward val="2"/>
            <c:dispRSqr val="0"/>
            <c:dispEq val="1"/>
            <c:trendlineLbl>
              <c:layout>
                <c:manualLayout>
                  <c:x val="-6.7244058069202278E-3"/>
                  <c:y val="4.7134528370557219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BMIとP1!$L$3:$L$45</c:f>
              <c:numCache>
                <c:formatCode>0.00_);[Red]\(0.00\)</c:formatCode>
                <c:ptCount val="43"/>
                <c:pt idx="0">
                  <c:v>20.38053662803819</c:v>
                </c:pt>
                <c:pt idx="1">
                  <c:v>26.099343924331905</c:v>
                </c:pt>
                <c:pt idx="2">
                  <c:v>18.692783015854182</c:v>
                </c:pt>
                <c:pt idx="3">
                  <c:v>18.452693122001442</c:v>
                </c:pt>
                <c:pt idx="4">
                  <c:v>27.852893455922125</c:v>
                </c:pt>
                <c:pt idx="5">
                  <c:v>20.000625762152559</c:v>
                </c:pt>
                <c:pt idx="6">
                  <c:v>27.571587066779376</c:v>
                </c:pt>
                <c:pt idx="7">
                  <c:v>28.30425880916177</c:v>
                </c:pt>
                <c:pt idx="8">
                  <c:v>21.453287197231838</c:v>
                </c:pt>
                <c:pt idx="9">
                  <c:v>22.735768578247658</c:v>
                </c:pt>
                <c:pt idx="10">
                  <c:v>22.089684117517116</c:v>
                </c:pt>
                <c:pt idx="11">
                  <c:v>19.515856633514733</c:v>
                </c:pt>
                <c:pt idx="12">
                  <c:v>16.748842636154919</c:v>
                </c:pt>
                <c:pt idx="13">
                  <c:v>21.203105228959341</c:v>
                </c:pt>
                <c:pt idx="14">
                  <c:v>23.804800634794685</c:v>
                </c:pt>
                <c:pt idx="15">
                  <c:v>20.042001460920382</c:v>
                </c:pt>
                <c:pt idx="16">
                  <c:v>19.474810977758942</c:v>
                </c:pt>
                <c:pt idx="17">
                  <c:v>28.263054422207073</c:v>
                </c:pt>
                <c:pt idx="18">
                  <c:v>25.910684346898332</c:v>
                </c:pt>
                <c:pt idx="19">
                  <c:v>24.981154392712519</c:v>
                </c:pt>
                <c:pt idx="20">
                  <c:v>25.92098272481903</c:v>
                </c:pt>
                <c:pt idx="23">
                  <c:v>24.007386888273317</c:v>
                </c:pt>
                <c:pt idx="24">
                  <c:v>27.221577893011531</c:v>
                </c:pt>
                <c:pt idx="25">
                  <c:v>21.701865426008318</c:v>
                </c:pt>
                <c:pt idx="26">
                  <c:v>29.242108636436463</c:v>
                </c:pt>
                <c:pt idx="27">
                  <c:v>19.817844493169169</c:v>
                </c:pt>
                <c:pt idx="28">
                  <c:v>16.446907981299521</c:v>
                </c:pt>
                <c:pt idx="29">
                  <c:v>17.538988384469434</c:v>
                </c:pt>
                <c:pt idx="30">
                  <c:v>18.875900874291116</c:v>
                </c:pt>
                <c:pt idx="31">
                  <c:v>21.951313606728132</c:v>
                </c:pt>
                <c:pt idx="32">
                  <c:v>16.600258275294976</c:v>
                </c:pt>
                <c:pt idx="33">
                  <c:v>19.602980597772813</c:v>
                </c:pt>
                <c:pt idx="34">
                  <c:v>22.000306091215183</c:v>
                </c:pt>
                <c:pt idx="35">
                  <c:v>20.21169662194194</c:v>
                </c:pt>
                <c:pt idx="36">
                  <c:v>35.19766530844236</c:v>
                </c:pt>
                <c:pt idx="37">
                  <c:v>17.373010054878044</c:v>
                </c:pt>
                <c:pt idx="38">
                  <c:v>18.734402126736111</c:v>
                </c:pt>
                <c:pt idx="39">
                  <c:v>17.241257356269806</c:v>
                </c:pt>
                <c:pt idx="40">
                  <c:v>18.071629730617282</c:v>
                </c:pt>
                <c:pt idx="41">
                  <c:v>26.76718969094404</c:v>
                </c:pt>
                <c:pt idx="42">
                  <c:v>22.222222222222221</c:v>
                </c:pt>
              </c:numCache>
            </c:numRef>
          </c:xVal>
          <c:yVal>
            <c:numRef>
              <c:f>BMIとP1!$K$3:$K$45</c:f>
              <c:numCache>
                <c:formatCode>General</c:formatCode>
                <c:ptCount val="43"/>
                <c:pt idx="0">
                  <c:v>187</c:v>
                </c:pt>
                <c:pt idx="1">
                  <c:v>186</c:v>
                </c:pt>
                <c:pt idx="2" formatCode="@">
                  <c:v>0</c:v>
                </c:pt>
                <c:pt idx="3">
                  <c:v>564</c:v>
                </c:pt>
                <c:pt idx="4">
                  <c:v>157</c:v>
                </c:pt>
                <c:pt idx="5">
                  <c:v>730</c:v>
                </c:pt>
                <c:pt idx="6">
                  <c:v>251</c:v>
                </c:pt>
                <c:pt idx="8">
                  <c:v>266</c:v>
                </c:pt>
                <c:pt idx="10">
                  <c:v>402</c:v>
                </c:pt>
                <c:pt idx="11">
                  <c:v>477</c:v>
                </c:pt>
                <c:pt idx="12">
                  <c:v>375</c:v>
                </c:pt>
                <c:pt idx="13">
                  <c:v>156</c:v>
                </c:pt>
                <c:pt idx="14">
                  <c:v>131</c:v>
                </c:pt>
                <c:pt idx="15">
                  <c:v>368</c:v>
                </c:pt>
                <c:pt idx="16">
                  <c:v>508</c:v>
                </c:pt>
                <c:pt idx="17">
                  <c:v>165</c:v>
                </c:pt>
                <c:pt idx="18">
                  <c:v>176</c:v>
                </c:pt>
                <c:pt idx="19">
                  <c:v>149</c:v>
                </c:pt>
                <c:pt idx="20">
                  <c:v>848</c:v>
                </c:pt>
                <c:pt idx="23">
                  <c:v>164</c:v>
                </c:pt>
                <c:pt idx="24">
                  <c:v>334</c:v>
                </c:pt>
                <c:pt idx="25">
                  <c:v>123</c:v>
                </c:pt>
                <c:pt idx="26">
                  <c:v>235</c:v>
                </c:pt>
                <c:pt idx="27">
                  <c:v>372</c:v>
                </c:pt>
                <c:pt idx="28">
                  <c:v>283</c:v>
                </c:pt>
                <c:pt idx="29">
                  <c:v>216</c:v>
                </c:pt>
                <c:pt idx="30">
                  <c:v>161</c:v>
                </c:pt>
                <c:pt idx="31">
                  <c:v>69.7</c:v>
                </c:pt>
                <c:pt idx="32">
                  <c:v>339</c:v>
                </c:pt>
                <c:pt idx="33">
                  <c:v>227</c:v>
                </c:pt>
                <c:pt idx="34">
                  <c:v>90.6</c:v>
                </c:pt>
                <c:pt idx="35">
                  <c:v>136</c:v>
                </c:pt>
                <c:pt idx="36">
                  <c:v>209</c:v>
                </c:pt>
                <c:pt idx="37">
                  <c:v>276</c:v>
                </c:pt>
                <c:pt idx="38">
                  <c:v>260</c:v>
                </c:pt>
                <c:pt idx="39">
                  <c:v>198</c:v>
                </c:pt>
                <c:pt idx="40">
                  <c:v>335</c:v>
                </c:pt>
                <c:pt idx="42">
                  <c:v>17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201-6641-8A06-0C2EE75424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32494847"/>
        <c:axId val="1032496527"/>
      </c:scatterChart>
      <c:valAx>
        <c:axId val="1032494847"/>
        <c:scaling>
          <c:orientation val="minMax"/>
          <c:min val="15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_);[Red]\(0.00\)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32496527"/>
        <c:crosses val="autoZero"/>
        <c:crossBetween val="midCat"/>
      </c:valAx>
      <c:valAx>
        <c:axId val="103249652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32494847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P3P4経過!$D$90</c:f>
              <c:strCache>
                <c:ptCount val="1"/>
                <c:pt idx="0">
                  <c:v>OC-19</c:v>
                </c:pt>
              </c:strCache>
            </c:strRef>
          </c:tx>
          <c:spPr>
            <a:ln w="19050" cap="rnd">
              <a:solidFill>
                <a:schemeClr val="tx1">
                  <a:lumMod val="95000"/>
                  <a:lumOff val="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strRef>
              <c:f>P3P4経過!$E$89:$H$89</c:f>
              <c:strCache>
                <c:ptCount val="4"/>
                <c:pt idx="0">
                  <c:v>P1</c:v>
                </c:pt>
                <c:pt idx="1">
                  <c:v>P2</c:v>
                </c:pt>
                <c:pt idx="2">
                  <c:v>P3</c:v>
                </c:pt>
                <c:pt idx="3">
                  <c:v>P4</c:v>
                </c:pt>
              </c:strCache>
            </c:strRef>
          </c:xVal>
          <c:yVal>
            <c:numRef>
              <c:f>P3P4経過!$E$90:$H$90</c:f>
              <c:numCache>
                <c:formatCode>General</c:formatCode>
                <c:ptCount val="4"/>
                <c:pt idx="0">
                  <c:v>176</c:v>
                </c:pt>
                <c:pt idx="2">
                  <c:v>290</c:v>
                </c:pt>
                <c:pt idx="3">
                  <c:v>11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8E6-C843-A9D9-9D2E8E605FA7}"/>
            </c:ext>
          </c:extLst>
        </c:ser>
        <c:ser>
          <c:idx val="1"/>
          <c:order val="1"/>
          <c:tx>
            <c:strRef>
              <c:f>P3P4経過!$D$91</c:f>
              <c:strCache>
                <c:ptCount val="1"/>
                <c:pt idx="0">
                  <c:v>OC-21</c:v>
                </c:pt>
              </c:strCache>
            </c:strRef>
          </c:tx>
          <c:spPr>
            <a:ln w="19050" cap="rnd">
              <a:solidFill>
                <a:schemeClr val="tx1">
                  <a:lumMod val="95000"/>
                  <a:lumOff val="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strRef>
              <c:f>P3P4経過!$E$89:$H$89</c:f>
              <c:strCache>
                <c:ptCount val="4"/>
                <c:pt idx="0">
                  <c:v>P1</c:v>
                </c:pt>
                <c:pt idx="1">
                  <c:v>P2</c:v>
                </c:pt>
                <c:pt idx="2">
                  <c:v>P3</c:v>
                </c:pt>
                <c:pt idx="3">
                  <c:v>P4</c:v>
                </c:pt>
              </c:strCache>
            </c:strRef>
          </c:xVal>
          <c:yVal>
            <c:numRef>
              <c:f>P3P4経過!$E$91:$H$91</c:f>
              <c:numCache>
                <c:formatCode>General</c:formatCode>
                <c:ptCount val="4"/>
                <c:pt idx="0">
                  <c:v>848</c:v>
                </c:pt>
                <c:pt idx="1">
                  <c:v>208</c:v>
                </c:pt>
                <c:pt idx="2">
                  <c:v>18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8E6-C843-A9D9-9D2E8E605FA7}"/>
            </c:ext>
          </c:extLst>
        </c:ser>
        <c:ser>
          <c:idx val="2"/>
          <c:order val="2"/>
          <c:tx>
            <c:strRef>
              <c:f>P3P4経過!$D$92</c:f>
              <c:strCache>
                <c:ptCount val="1"/>
                <c:pt idx="0">
                  <c:v>OC-33</c:v>
                </c:pt>
              </c:strCache>
            </c:strRef>
          </c:tx>
          <c:spPr>
            <a:ln w="19050" cap="rnd">
              <a:solidFill>
                <a:schemeClr val="tx1">
                  <a:lumMod val="95000"/>
                  <a:lumOff val="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strRef>
              <c:f>P3P4経過!$E$89:$H$89</c:f>
              <c:strCache>
                <c:ptCount val="4"/>
                <c:pt idx="0">
                  <c:v>P1</c:v>
                </c:pt>
                <c:pt idx="1">
                  <c:v>P2</c:v>
                </c:pt>
                <c:pt idx="2">
                  <c:v>P3</c:v>
                </c:pt>
                <c:pt idx="3">
                  <c:v>P4</c:v>
                </c:pt>
              </c:strCache>
            </c:strRef>
          </c:xVal>
          <c:yVal>
            <c:numRef>
              <c:f>P3P4経過!$E$92:$H$92</c:f>
              <c:numCache>
                <c:formatCode>General</c:formatCode>
                <c:ptCount val="4"/>
                <c:pt idx="0">
                  <c:v>339</c:v>
                </c:pt>
                <c:pt idx="2">
                  <c:v>152</c:v>
                </c:pt>
                <c:pt idx="3">
                  <c:v>17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8E6-C843-A9D9-9D2E8E605FA7}"/>
            </c:ext>
          </c:extLst>
        </c:ser>
        <c:ser>
          <c:idx val="3"/>
          <c:order val="3"/>
          <c:tx>
            <c:strRef>
              <c:f>P3P4経過!$D$93</c:f>
              <c:strCache>
                <c:ptCount val="1"/>
                <c:pt idx="0">
                  <c:v>OC-34</c:v>
                </c:pt>
              </c:strCache>
            </c:strRef>
          </c:tx>
          <c:spPr>
            <a:ln w="19050" cap="rnd">
              <a:solidFill>
                <a:schemeClr val="tx1">
                  <a:lumMod val="95000"/>
                  <a:lumOff val="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strRef>
              <c:f>P3P4経過!$E$89:$H$89</c:f>
              <c:strCache>
                <c:ptCount val="4"/>
                <c:pt idx="0">
                  <c:v>P1</c:v>
                </c:pt>
                <c:pt idx="1">
                  <c:v>P2</c:v>
                </c:pt>
                <c:pt idx="2">
                  <c:v>P3</c:v>
                </c:pt>
                <c:pt idx="3">
                  <c:v>P4</c:v>
                </c:pt>
              </c:strCache>
            </c:strRef>
          </c:xVal>
          <c:yVal>
            <c:numRef>
              <c:f>P3P4経過!$E$93:$H$93</c:f>
              <c:numCache>
                <c:formatCode>General</c:formatCode>
                <c:ptCount val="4"/>
                <c:pt idx="0">
                  <c:v>227</c:v>
                </c:pt>
                <c:pt idx="2">
                  <c:v>14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98E6-C843-A9D9-9D2E8E605FA7}"/>
            </c:ext>
          </c:extLst>
        </c:ser>
        <c:ser>
          <c:idx val="4"/>
          <c:order val="4"/>
          <c:tx>
            <c:strRef>
              <c:f>P3P4経過!$D$94</c:f>
              <c:strCache>
                <c:ptCount val="1"/>
                <c:pt idx="0">
                  <c:v>OC-41</c:v>
                </c:pt>
              </c:strCache>
            </c:strRef>
          </c:tx>
          <c:spPr>
            <a:ln w="19050" cap="rnd">
              <a:solidFill>
                <a:schemeClr val="tx1">
                  <a:lumMod val="95000"/>
                  <a:lumOff val="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strRef>
              <c:f>P3P4経過!$E$89:$H$89</c:f>
              <c:strCache>
                <c:ptCount val="4"/>
                <c:pt idx="0">
                  <c:v>P1</c:v>
                </c:pt>
                <c:pt idx="1">
                  <c:v>P2</c:v>
                </c:pt>
                <c:pt idx="2">
                  <c:v>P3</c:v>
                </c:pt>
                <c:pt idx="3">
                  <c:v>P4</c:v>
                </c:pt>
              </c:strCache>
            </c:strRef>
          </c:xVal>
          <c:yVal>
            <c:numRef>
              <c:f>P3P4経過!$E$94:$H$94</c:f>
              <c:numCache>
                <c:formatCode>General</c:formatCode>
                <c:ptCount val="4"/>
                <c:pt idx="0">
                  <c:v>335</c:v>
                </c:pt>
                <c:pt idx="1">
                  <c:v>653</c:v>
                </c:pt>
                <c:pt idx="2">
                  <c:v>25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98E6-C843-A9D9-9D2E8E605F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41052608"/>
        <c:axId val="841167872"/>
      </c:scatterChart>
      <c:valAx>
        <c:axId val="841052608"/>
        <c:scaling>
          <c:orientation val="minMax"/>
          <c:min val="0.5"/>
        </c:scaling>
        <c:delete val="1"/>
        <c:axPos val="b"/>
        <c:majorTickMark val="none"/>
        <c:minorTickMark val="none"/>
        <c:tickLblPos val="nextTo"/>
        <c:crossAx val="841167872"/>
        <c:crosses val="autoZero"/>
        <c:crossBetween val="midCat"/>
        <c:majorUnit val="1"/>
      </c:valAx>
      <c:valAx>
        <c:axId val="8411678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HGMaruGothicMPRO" panose="020F0600000000000000" pitchFamily="34" charset="-128"/>
                <a:cs typeface="+mn-cs"/>
              </a:defRPr>
            </a:pPr>
            <a:endParaRPr lang="ja-JP"/>
          </a:p>
        </c:txPr>
        <c:crossAx val="841052608"/>
        <c:crosses val="autoZero"/>
        <c:crossBetween val="midCat"/>
      </c:valAx>
      <c:spPr>
        <a:noFill/>
        <a:ln>
          <a:noFill/>
        </a:ln>
        <a:effectLst/>
      </c:spPr>
    </c:plotArea>
    <c:plotVisOnly val="0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6846F8-526A-1342-9D15-CECCAE248A6C}" type="datetimeFigureOut">
              <a:rPr kumimoji="1" lang="ja-JP" altLang="en-US" smtClean="0"/>
              <a:t>2023/7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19EF090-F469-E14B-883E-612785F5B0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30851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C4BD7-FD5D-2448-B15C-588EB74B8CE5}" type="datetimeFigureOut">
              <a:rPr kumimoji="1" lang="ja-JP" altLang="en-US" smtClean="0"/>
              <a:t>2023/7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6E12D-4C43-C549-A076-6C790A8866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5395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C4BD7-FD5D-2448-B15C-588EB74B8CE5}" type="datetimeFigureOut">
              <a:rPr kumimoji="1" lang="ja-JP" altLang="en-US" smtClean="0"/>
              <a:t>2023/7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6E12D-4C43-C549-A076-6C790A8866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6874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C4BD7-FD5D-2448-B15C-588EB74B8CE5}" type="datetimeFigureOut">
              <a:rPr kumimoji="1" lang="ja-JP" altLang="en-US" smtClean="0"/>
              <a:t>2023/7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6E12D-4C43-C549-A076-6C790A8866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10586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C4BD7-FD5D-2448-B15C-588EB74B8CE5}" type="datetimeFigureOut">
              <a:rPr kumimoji="1" lang="ja-JP" altLang="en-US" smtClean="0"/>
              <a:t>2023/7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6E12D-4C43-C549-A076-6C790A8866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27256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C4BD7-FD5D-2448-B15C-588EB74B8CE5}" type="datetimeFigureOut">
              <a:rPr kumimoji="1" lang="ja-JP" altLang="en-US" smtClean="0"/>
              <a:t>2023/7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6E12D-4C43-C549-A076-6C790A8866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36797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C4BD7-FD5D-2448-B15C-588EB74B8CE5}" type="datetimeFigureOut">
              <a:rPr kumimoji="1" lang="ja-JP" altLang="en-US" smtClean="0"/>
              <a:t>2023/7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6E12D-4C43-C549-A076-6C790A8866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11447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C4BD7-FD5D-2448-B15C-588EB74B8CE5}" type="datetimeFigureOut">
              <a:rPr kumimoji="1" lang="ja-JP" altLang="en-US" smtClean="0"/>
              <a:t>2023/7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6E12D-4C43-C549-A076-6C790A8866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20704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C4BD7-FD5D-2448-B15C-588EB74B8CE5}" type="datetimeFigureOut">
              <a:rPr kumimoji="1" lang="ja-JP" altLang="en-US" smtClean="0"/>
              <a:t>2023/7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6E12D-4C43-C549-A076-6C790A8866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99258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C4BD7-FD5D-2448-B15C-588EB74B8CE5}" type="datetimeFigureOut">
              <a:rPr kumimoji="1" lang="ja-JP" altLang="en-US" smtClean="0"/>
              <a:t>2023/7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6E12D-4C43-C549-A076-6C790A8866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37092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C4BD7-FD5D-2448-B15C-588EB74B8CE5}" type="datetimeFigureOut">
              <a:rPr kumimoji="1" lang="ja-JP" altLang="en-US" smtClean="0"/>
              <a:t>2023/7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6E12D-4C43-C549-A076-6C790A8866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37751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C4BD7-FD5D-2448-B15C-588EB74B8CE5}" type="datetimeFigureOut">
              <a:rPr kumimoji="1" lang="ja-JP" altLang="en-US" smtClean="0"/>
              <a:t>2023/7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6E12D-4C43-C549-A076-6C790A8866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83932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8C4BD7-FD5D-2448-B15C-588EB74B8CE5}" type="datetimeFigureOut">
              <a:rPr kumimoji="1" lang="ja-JP" altLang="en-US" smtClean="0"/>
              <a:t>2023/7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26E12D-4C43-C549-A076-6C790A8866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15924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18" Type="http://schemas.openxmlformats.org/officeDocument/2006/relationships/image" Target="../media/image1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" Type="http://schemas.openxmlformats.org/officeDocument/2006/relationships/image" Target="../media/image1.emf"/><Relationship Id="rId16" Type="http://schemas.openxmlformats.org/officeDocument/2006/relationships/image" Target="../media/image15.emf"/><Relationship Id="rId20" Type="http://schemas.openxmlformats.org/officeDocument/2006/relationships/image" Target="../media/image1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19" Type="http://schemas.openxmlformats.org/officeDocument/2006/relationships/image" Target="../media/image18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F37A768F-1A9A-5743-A130-5F6CAA758E3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35407713"/>
              </p:ext>
            </p:extLst>
          </p:nvPr>
        </p:nvGraphicFramePr>
        <p:xfrm>
          <a:off x="1192654" y="1124744"/>
          <a:ext cx="8352928" cy="39891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0BF7BB3-8D79-ED4B-BA69-A0D488F758ED}"/>
              </a:ext>
            </a:extLst>
          </p:cNvPr>
          <p:cNvSpPr txBox="1"/>
          <p:nvPr/>
        </p:nvSpPr>
        <p:spPr>
          <a:xfrm>
            <a:off x="168164" y="91966"/>
            <a:ext cx="255258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Supplementary Figure 1</a:t>
            </a:r>
          </a:p>
          <a:p>
            <a:r>
              <a:rPr lang="en-US" altLang="ja-JP" sz="1400" dirty="0">
                <a:latin typeface="Helvetica" pitchFamily="2" charset="0"/>
              </a:rPr>
              <a:t>Fukuhara et al.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408DB32-D19B-1C4D-AAC0-73393142EF0C}"/>
              </a:ext>
            </a:extLst>
          </p:cNvPr>
          <p:cNvSpPr txBox="1"/>
          <p:nvPr/>
        </p:nvSpPr>
        <p:spPr>
          <a:xfrm>
            <a:off x="0" y="1196753"/>
            <a:ext cx="2108548" cy="369331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altLang="ja-JP" dirty="0">
                <a:latin typeface="Times" pitchFamily="2" charset="0"/>
              </a:rPr>
              <a:t>Anemia</a:t>
            </a:r>
          </a:p>
          <a:p>
            <a:pPr algn="r"/>
            <a:r>
              <a:rPr lang="en-US" altLang="ja-JP" dirty="0">
                <a:latin typeface="Times" pitchFamily="2" charset="0"/>
              </a:rPr>
              <a:t>Thrombocytopenia </a:t>
            </a:r>
          </a:p>
          <a:p>
            <a:pPr algn="r"/>
            <a:r>
              <a:rPr lang="en-US" altLang="ja-JP" dirty="0">
                <a:latin typeface="Times" pitchFamily="2" charset="0"/>
              </a:rPr>
              <a:t>Diarrhea</a:t>
            </a:r>
          </a:p>
          <a:p>
            <a:pPr algn="r"/>
            <a:r>
              <a:rPr lang="en-US" altLang="ja-JP" dirty="0">
                <a:latin typeface="Times" pitchFamily="2" charset="0"/>
              </a:rPr>
              <a:t>Anorexia</a:t>
            </a:r>
          </a:p>
          <a:p>
            <a:pPr algn="r"/>
            <a:r>
              <a:rPr lang="en-US" altLang="ja-JP" dirty="0">
                <a:latin typeface="Times" pitchFamily="2" charset="0"/>
              </a:rPr>
              <a:t>Vomiting</a:t>
            </a:r>
          </a:p>
          <a:p>
            <a:pPr algn="r"/>
            <a:r>
              <a:rPr lang="en-US" altLang="ja-JP" dirty="0">
                <a:latin typeface="Times" pitchFamily="2" charset="0"/>
              </a:rPr>
              <a:t>Nausea</a:t>
            </a:r>
          </a:p>
          <a:p>
            <a:pPr algn="r"/>
            <a:r>
              <a:rPr lang="en-US" altLang="ja-JP" dirty="0">
                <a:latin typeface="Times" pitchFamily="2" charset="0"/>
              </a:rPr>
              <a:t>Paronychia</a:t>
            </a:r>
          </a:p>
          <a:p>
            <a:pPr algn="r"/>
            <a:r>
              <a:rPr lang="en-US" altLang="ja-JP" dirty="0">
                <a:latin typeface="Times" pitchFamily="2" charset="0"/>
              </a:rPr>
              <a:t>Rash</a:t>
            </a:r>
          </a:p>
          <a:p>
            <a:pPr algn="r"/>
            <a:r>
              <a:rPr lang="en-US" altLang="ja-JP" dirty="0">
                <a:latin typeface="Times" pitchFamily="2" charset="0"/>
              </a:rPr>
              <a:t>Leukocytopenia</a:t>
            </a:r>
          </a:p>
          <a:p>
            <a:pPr algn="r"/>
            <a:r>
              <a:rPr lang="en-US" altLang="ja-JP" dirty="0">
                <a:latin typeface="Times" pitchFamily="2" charset="0"/>
              </a:rPr>
              <a:t>Liver dysfunction</a:t>
            </a:r>
          </a:p>
          <a:p>
            <a:pPr algn="r"/>
            <a:r>
              <a:rPr lang="en-US" altLang="ja-JP" dirty="0">
                <a:latin typeface="Times" pitchFamily="2" charset="0"/>
              </a:rPr>
              <a:t>Neutropenia</a:t>
            </a:r>
          </a:p>
          <a:p>
            <a:pPr algn="r"/>
            <a:r>
              <a:rPr lang="en-US" altLang="ja-JP" dirty="0">
                <a:latin typeface="Times" pitchFamily="2" charset="0"/>
              </a:rPr>
              <a:t>QT prolongation</a:t>
            </a:r>
          </a:p>
          <a:p>
            <a:pPr algn="r"/>
            <a:r>
              <a:rPr lang="en-US" altLang="ja-JP" dirty="0">
                <a:latin typeface="Times" pitchFamily="2" charset="0"/>
              </a:rPr>
              <a:t>Pneumonitis</a:t>
            </a:r>
          </a:p>
        </p:txBody>
      </p:sp>
      <p:sp>
        <p:nvSpPr>
          <p:cNvPr id="7" name="テキスト ボックス 7">
            <a:extLst>
              <a:ext uri="{FF2B5EF4-FFF2-40B4-BE49-F238E27FC236}">
                <a16:creationId xmlns:a16="http://schemas.microsoft.com/office/drawing/2014/main" id="{E291F65C-53B4-F741-9D5C-54D1039A51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38966" y="5113907"/>
            <a:ext cx="1440160" cy="3627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no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r>
              <a:rPr lang="en-US" altLang="ja-JP" sz="1400" dirty="0">
                <a:solidFill>
                  <a:schemeClr val="tx1">
                    <a:lumMod val="75000"/>
                    <a:lumOff val="25000"/>
                  </a:schemeClr>
                </a:solidFill>
                <a:latin typeface="Times" pitchFamily="2" charset="0"/>
                <a:ea typeface="HG丸ｺﾞｼｯｸM-PRO" charset="-128"/>
              </a:rPr>
              <a:t>Frequency(%)</a:t>
            </a: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303A7FD1-94A0-C549-8899-ADABC25A7FCD}"/>
              </a:ext>
            </a:extLst>
          </p:cNvPr>
          <p:cNvSpPr/>
          <p:nvPr/>
        </p:nvSpPr>
        <p:spPr>
          <a:xfrm>
            <a:off x="6377368" y="4516471"/>
            <a:ext cx="181396" cy="181396"/>
          </a:xfrm>
          <a:prstGeom prst="rect">
            <a:avLst/>
          </a:prstGeom>
          <a:solidFill>
            <a:srgbClr val="4472C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6BC4F906-3025-E047-B431-CA89379F865B}"/>
              </a:ext>
            </a:extLst>
          </p:cNvPr>
          <p:cNvSpPr/>
          <p:nvPr/>
        </p:nvSpPr>
        <p:spPr>
          <a:xfrm>
            <a:off x="7631892" y="4510405"/>
            <a:ext cx="181396" cy="181396"/>
          </a:xfrm>
          <a:prstGeom prst="rect">
            <a:avLst/>
          </a:prstGeom>
          <a:solidFill>
            <a:srgbClr val="ED7D3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F3787D2-E6A2-EB49-B2B2-76AC0CDC2A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37176" y="4446443"/>
            <a:ext cx="1094716" cy="3627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no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r>
              <a:rPr lang="en-US" altLang="ja-JP" sz="1400" dirty="0">
                <a:solidFill>
                  <a:schemeClr val="tx1">
                    <a:lumMod val="75000"/>
                    <a:lumOff val="25000"/>
                  </a:schemeClr>
                </a:solidFill>
                <a:latin typeface="Times" pitchFamily="2" charset="0"/>
                <a:ea typeface="HG丸ｺﾞｼｯｸM-PRO" charset="-128"/>
              </a:rPr>
              <a:t>All Grade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092A89F-3B87-6D42-BD59-FA93CB02D2C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01015" y="4446443"/>
            <a:ext cx="1192654" cy="3627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no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r>
              <a:rPr lang="ja-JP" altLang="en-US" sz="1400">
                <a:solidFill>
                  <a:schemeClr val="tx1">
                    <a:lumMod val="75000"/>
                    <a:lumOff val="25000"/>
                  </a:schemeClr>
                </a:solidFill>
                <a:latin typeface="Times" pitchFamily="2" charset="0"/>
                <a:ea typeface="HG丸ｺﾞｼｯｸM-PRO" charset="-128"/>
              </a:rPr>
              <a:t>≧</a:t>
            </a:r>
            <a:r>
              <a:rPr lang="en-US" altLang="ja-JP" sz="1400" dirty="0">
                <a:solidFill>
                  <a:schemeClr val="tx1">
                    <a:lumMod val="75000"/>
                    <a:lumOff val="25000"/>
                  </a:schemeClr>
                </a:solidFill>
                <a:latin typeface="Times" pitchFamily="2" charset="0"/>
                <a:ea typeface="HG丸ｺﾞｼｯｸM-PRO" charset="-128"/>
              </a:rPr>
              <a:t> Grade 3</a:t>
            </a:r>
          </a:p>
        </p:txBody>
      </p:sp>
      <p:sp>
        <p:nvSpPr>
          <p:cNvPr id="12" name="テキスト ボックス 7">
            <a:extLst>
              <a:ext uri="{FF2B5EF4-FFF2-40B4-BE49-F238E27FC236}">
                <a16:creationId xmlns:a16="http://schemas.microsoft.com/office/drawing/2014/main" id="{F4744C1B-5304-FF4B-A03D-C23C59A4BEF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18379" y="4869160"/>
            <a:ext cx="403190" cy="362792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no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r>
              <a:rPr lang="en-US" altLang="ja-JP" sz="1400" dirty="0">
                <a:solidFill>
                  <a:schemeClr val="tx1">
                    <a:lumMod val="75000"/>
                    <a:lumOff val="25000"/>
                  </a:schemeClr>
                </a:solidFill>
                <a:latin typeface="Times" pitchFamily="2" charset="0"/>
                <a:ea typeface="HG丸ｺﾞｼｯｸM-PRO" charset="-128"/>
              </a:rPr>
              <a:t>0</a:t>
            </a:r>
          </a:p>
        </p:txBody>
      </p:sp>
      <p:sp>
        <p:nvSpPr>
          <p:cNvPr id="13" name="テキスト ボックス 7">
            <a:extLst>
              <a:ext uri="{FF2B5EF4-FFF2-40B4-BE49-F238E27FC236}">
                <a16:creationId xmlns:a16="http://schemas.microsoft.com/office/drawing/2014/main" id="{014C11DC-33B3-6D49-A72E-CAB11E76F2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57722" y="4869160"/>
            <a:ext cx="403190" cy="362792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no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r>
              <a:rPr lang="en-US" altLang="ja-JP" sz="1400" dirty="0">
                <a:solidFill>
                  <a:schemeClr val="tx1">
                    <a:lumMod val="75000"/>
                    <a:lumOff val="25000"/>
                  </a:schemeClr>
                </a:solidFill>
                <a:latin typeface="Times" pitchFamily="2" charset="0"/>
                <a:ea typeface="HG丸ｺﾞｼｯｸM-PRO" charset="-128"/>
              </a:rPr>
              <a:t>10</a:t>
            </a:r>
          </a:p>
        </p:txBody>
      </p:sp>
      <p:sp>
        <p:nvSpPr>
          <p:cNvPr id="14" name="テキスト ボックス 7">
            <a:extLst>
              <a:ext uri="{FF2B5EF4-FFF2-40B4-BE49-F238E27FC236}">
                <a16:creationId xmlns:a16="http://schemas.microsoft.com/office/drawing/2014/main" id="{C4277968-FA69-DD44-BB8D-23BEAE91F7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57922" y="4869160"/>
            <a:ext cx="403190" cy="362792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no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r>
              <a:rPr lang="en-US" altLang="ja-JP" sz="1400" dirty="0">
                <a:solidFill>
                  <a:schemeClr val="tx1">
                    <a:lumMod val="75000"/>
                    <a:lumOff val="25000"/>
                  </a:schemeClr>
                </a:solidFill>
                <a:latin typeface="Times" pitchFamily="2" charset="0"/>
                <a:ea typeface="HG丸ｺﾞｼｯｸM-PRO" charset="-128"/>
              </a:rPr>
              <a:t>20</a:t>
            </a:r>
          </a:p>
        </p:txBody>
      </p:sp>
      <p:sp>
        <p:nvSpPr>
          <p:cNvPr id="15" name="テキスト ボックス 7">
            <a:extLst>
              <a:ext uri="{FF2B5EF4-FFF2-40B4-BE49-F238E27FC236}">
                <a16:creationId xmlns:a16="http://schemas.microsoft.com/office/drawing/2014/main" id="{B8EA28E3-AF35-664F-9846-4913718017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50157" y="4869160"/>
            <a:ext cx="403190" cy="362792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no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r>
              <a:rPr lang="en-US" altLang="ja-JP" sz="1400" dirty="0">
                <a:solidFill>
                  <a:schemeClr val="tx1">
                    <a:lumMod val="75000"/>
                    <a:lumOff val="25000"/>
                  </a:schemeClr>
                </a:solidFill>
                <a:latin typeface="Times" pitchFamily="2" charset="0"/>
                <a:ea typeface="HG丸ｺﾞｼｯｸM-PRO" charset="-128"/>
              </a:rPr>
              <a:t>30</a:t>
            </a:r>
          </a:p>
        </p:txBody>
      </p:sp>
      <p:sp>
        <p:nvSpPr>
          <p:cNvPr id="16" name="テキスト ボックス 7">
            <a:extLst>
              <a:ext uri="{FF2B5EF4-FFF2-40B4-BE49-F238E27FC236}">
                <a16:creationId xmlns:a16="http://schemas.microsoft.com/office/drawing/2014/main" id="{C482E8E3-DAF5-1445-BEC1-D232196C46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94928" y="4864077"/>
            <a:ext cx="403190" cy="362792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no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r>
              <a:rPr lang="en-US" altLang="ja-JP" sz="1400" dirty="0">
                <a:solidFill>
                  <a:schemeClr val="tx1">
                    <a:lumMod val="75000"/>
                    <a:lumOff val="25000"/>
                  </a:schemeClr>
                </a:solidFill>
                <a:latin typeface="Times" pitchFamily="2" charset="0"/>
                <a:ea typeface="HG丸ｺﾞｼｯｸM-PRO" charset="-128"/>
              </a:rPr>
              <a:t>40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318B9B51-8260-7945-80EF-5029007E3CC5}"/>
              </a:ext>
            </a:extLst>
          </p:cNvPr>
          <p:cNvSpPr txBox="1"/>
          <p:nvPr/>
        </p:nvSpPr>
        <p:spPr>
          <a:xfrm>
            <a:off x="640741" y="5892739"/>
            <a:ext cx="83529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" pitchFamily="2" charset="0"/>
              </a:rPr>
              <a:t>Supplementary Figure </a:t>
            </a:r>
            <a:r>
              <a:rPr lang="en-US" altLang="ja-JP" sz="1400" dirty="0">
                <a:latin typeface="Times" pitchFamily="2" charset="0"/>
              </a:rPr>
              <a:t>1. Frequency of adverse effects during </a:t>
            </a:r>
            <a:r>
              <a:rPr lang="en-US" altLang="ja-JP" sz="1400" dirty="0" err="1">
                <a:latin typeface="Times" pitchFamily="2" charset="0"/>
              </a:rPr>
              <a:t>osimertinib</a:t>
            </a:r>
            <a:r>
              <a:rPr lang="en-US" altLang="ja-JP" sz="1400" dirty="0">
                <a:latin typeface="Times" pitchFamily="2" charset="0"/>
              </a:rPr>
              <a:t> treatment.</a:t>
            </a:r>
            <a:endParaRPr kumimoji="1" lang="en-US" altLang="ja-JP" sz="1400" dirty="0">
              <a:latin typeface="Times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26924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5875D4F4-CBE5-FD46-B76E-ABA71EB4CF4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9739231"/>
              </p:ext>
            </p:extLst>
          </p:nvPr>
        </p:nvGraphicFramePr>
        <p:xfrm>
          <a:off x="390167" y="1484784"/>
          <a:ext cx="4184771" cy="26478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テキスト ボックス 7">
            <a:extLst>
              <a:ext uri="{FF2B5EF4-FFF2-40B4-BE49-F238E27FC236}">
                <a16:creationId xmlns:a16="http://schemas.microsoft.com/office/drawing/2014/main" id="{0327F124-8BDA-EE43-9236-F43C7ABE1939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544541" y="2489457"/>
            <a:ext cx="1864804" cy="374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no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r>
              <a:rPr lang="en-US" altLang="ja-JP" sz="1200" dirty="0">
                <a:solidFill>
                  <a:schemeClr val="tx1">
                    <a:lumMod val="75000"/>
                    <a:lumOff val="25000"/>
                  </a:schemeClr>
                </a:solidFill>
                <a:latin typeface="Times" pitchFamily="2" charset="0"/>
                <a:ea typeface="HG丸ｺﾞｼｯｸM-PRO" charset="-128"/>
                <a:cs typeface="Calibri" panose="020F0502020204030204" pitchFamily="34" charset="0"/>
              </a:rPr>
              <a:t>Osimertinib (ng/ml)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DAB08D5-4557-4848-B880-58BFB5DEFA89}"/>
              </a:ext>
            </a:extLst>
          </p:cNvPr>
          <p:cNvSpPr txBox="1"/>
          <p:nvPr/>
        </p:nvSpPr>
        <p:spPr>
          <a:xfrm>
            <a:off x="774764" y="4132608"/>
            <a:ext cx="341557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" altLang="ja-JP" sz="1200" dirty="0">
                <a:latin typeface="Times" pitchFamily="2" charset="0"/>
                <a:ea typeface="HGMaruGothicMPRO" panose="020F0600000000000000" pitchFamily="34" charset="-128"/>
                <a:cs typeface="Calibri" panose="020F0502020204030204" pitchFamily="34" charset="0"/>
              </a:rPr>
              <a:t>Spearman's Rank Correlation Coefficient was -0.237 </a:t>
            </a:r>
          </a:p>
          <a:p>
            <a:r>
              <a:rPr lang="en" altLang="ja-JP" sz="1200" dirty="0">
                <a:latin typeface="Times" pitchFamily="2" charset="0"/>
                <a:ea typeface="HGMaruGothicMPRO" panose="020F0600000000000000" pitchFamily="34" charset="-128"/>
                <a:cs typeface="Calibri" panose="020F0502020204030204" pitchFamily="34" charset="0"/>
              </a:rPr>
              <a:t>P= 0.15 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7E725BD-87C6-7F4C-973B-B7041A6EE6FE}"/>
              </a:ext>
            </a:extLst>
          </p:cNvPr>
          <p:cNvSpPr txBox="1"/>
          <p:nvPr/>
        </p:nvSpPr>
        <p:spPr>
          <a:xfrm>
            <a:off x="168164" y="91966"/>
            <a:ext cx="254922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Supplementary Figure 2</a:t>
            </a:r>
          </a:p>
          <a:p>
            <a:r>
              <a:rPr lang="en-US" altLang="ja-JP" sz="1400" dirty="0">
                <a:latin typeface="Helvetica" pitchFamily="2" charset="0"/>
              </a:rPr>
              <a:t>Fukuhara et al.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CBBA5DC-A9A7-FA42-81EA-9550CC3DCF18}"/>
              </a:ext>
            </a:extLst>
          </p:cNvPr>
          <p:cNvSpPr txBox="1"/>
          <p:nvPr/>
        </p:nvSpPr>
        <p:spPr>
          <a:xfrm>
            <a:off x="5567926" y="4132608"/>
            <a:ext cx="394903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" altLang="ja-JP" sz="1200" dirty="0">
                <a:latin typeface="Times" pitchFamily="2" charset="0"/>
                <a:ea typeface="HGMaruGothicMPRO" panose="020F0600000000000000" pitchFamily="34" charset="-128"/>
                <a:cs typeface="Calibri" panose="020F0502020204030204" pitchFamily="34" charset="0"/>
              </a:rPr>
              <a:t>Spearman's Rank Correlation Coefficient was -0.361</a:t>
            </a:r>
          </a:p>
          <a:p>
            <a:r>
              <a:rPr lang="en" altLang="ja-JP" sz="1200" dirty="0">
                <a:latin typeface="Times" pitchFamily="2" charset="0"/>
                <a:ea typeface="HGMaruGothicMPRO" panose="020F0600000000000000" pitchFamily="34" charset="-128"/>
                <a:cs typeface="Calibri" panose="020F0502020204030204" pitchFamily="34" charset="0"/>
              </a:rPr>
              <a:t>P= 0.03 </a:t>
            </a:r>
          </a:p>
          <a:p>
            <a:endParaRPr lang="ja-JP" altLang="en-US" sz="1200">
              <a:latin typeface="Times" pitchFamily="2" charset="0"/>
              <a:ea typeface="HGMaruGothicMPRO" panose="020F0600000000000000" pitchFamily="34" charset="-128"/>
            </a:endParaRPr>
          </a:p>
        </p:txBody>
      </p:sp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02D2FC58-15C5-454F-B1CC-09998A30D48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3844339"/>
              </p:ext>
            </p:extLst>
          </p:nvPr>
        </p:nvGraphicFramePr>
        <p:xfrm>
          <a:off x="5181524" y="1484784"/>
          <a:ext cx="4334309" cy="26478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3" name="テキスト ボックス 7">
            <a:extLst>
              <a:ext uri="{FF2B5EF4-FFF2-40B4-BE49-F238E27FC236}">
                <a16:creationId xmlns:a16="http://schemas.microsoft.com/office/drawing/2014/main" id="{859B176C-B283-6940-BA97-225641A70F0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249122" y="2489457"/>
            <a:ext cx="1864804" cy="374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no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r>
              <a:rPr lang="en-US" altLang="ja-JP" sz="1200" dirty="0">
                <a:solidFill>
                  <a:schemeClr val="tx1">
                    <a:lumMod val="75000"/>
                    <a:lumOff val="25000"/>
                  </a:schemeClr>
                </a:solidFill>
                <a:latin typeface="Times" pitchFamily="2" charset="0"/>
                <a:ea typeface="HG丸ｺﾞｼｯｸM-PRO" charset="-128"/>
                <a:cs typeface="Calibri" panose="020F0502020204030204" pitchFamily="34" charset="0"/>
              </a:rPr>
              <a:t>Osimertinib (ng/ml)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1637455-18D6-7B48-B23C-B045C86FF835}"/>
              </a:ext>
            </a:extLst>
          </p:cNvPr>
          <p:cNvSpPr txBox="1"/>
          <p:nvPr/>
        </p:nvSpPr>
        <p:spPr>
          <a:xfrm>
            <a:off x="640741" y="5892739"/>
            <a:ext cx="835292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" pitchFamily="2" charset="0"/>
              </a:rPr>
              <a:t>Supplementary Figure 2</a:t>
            </a:r>
            <a:r>
              <a:rPr lang="en-US" altLang="ja-JP" sz="1400" dirty="0">
                <a:latin typeface="Times" pitchFamily="2" charset="0"/>
              </a:rPr>
              <a:t>. Correlation between </a:t>
            </a:r>
            <a:r>
              <a:rPr lang="en-US" altLang="ja-JP" sz="1400" dirty="0" err="1">
                <a:latin typeface="Times" pitchFamily="2" charset="0"/>
              </a:rPr>
              <a:t>osimertinib</a:t>
            </a:r>
            <a:r>
              <a:rPr lang="en-US" altLang="ja-JP" sz="1400" dirty="0">
                <a:latin typeface="Times" pitchFamily="2" charset="0"/>
              </a:rPr>
              <a:t> trough concentration and body </a:t>
            </a:r>
            <a:r>
              <a:rPr lang="en-US" altLang="ja-JP" sz="1400" dirty="0" err="1">
                <a:latin typeface="Times" pitchFamily="2" charset="0"/>
              </a:rPr>
              <a:t>surfice</a:t>
            </a:r>
            <a:r>
              <a:rPr lang="en-US" altLang="ja-JP" sz="1400" dirty="0">
                <a:latin typeface="Times" pitchFamily="2" charset="0"/>
              </a:rPr>
              <a:t> area (BSA), body mass index (BMI). The formula for BSA</a:t>
            </a:r>
            <a:r>
              <a:rPr lang="ja-JP" altLang="en-US" sz="1400">
                <a:latin typeface="Times" pitchFamily="2" charset="0"/>
                <a:ea typeface="HGMaruGothicMPRO" panose="020F0600000000000000" pitchFamily="34" charset="-128"/>
                <a:cs typeface="Calibri" panose="020F0502020204030204" pitchFamily="34" charset="0"/>
              </a:rPr>
              <a:t> (Du Bois Method)</a:t>
            </a:r>
            <a:r>
              <a:rPr lang="en-US" altLang="ja-JP" sz="1400" dirty="0">
                <a:latin typeface="Times" pitchFamily="2" charset="0"/>
              </a:rPr>
              <a:t> and BMI were </a:t>
            </a:r>
            <a:r>
              <a:rPr lang="ja-JP" altLang="en-US" sz="1400">
                <a:latin typeface="Times" pitchFamily="2" charset="0"/>
                <a:ea typeface="HGMaruGothicMPRO" panose="020F0600000000000000" pitchFamily="34" charset="-128"/>
                <a:cs typeface="Calibri" panose="020F0502020204030204" pitchFamily="34" charset="0"/>
              </a:rPr>
              <a:t>0.007184 * Height</a:t>
            </a:r>
            <a:r>
              <a:rPr lang="ja-JP" altLang="en-US" sz="1400" baseline="30000">
                <a:latin typeface="Times" pitchFamily="2" charset="0"/>
                <a:ea typeface="HGMaruGothicMPRO" panose="020F0600000000000000" pitchFamily="34" charset="-128"/>
                <a:cs typeface="Calibri" panose="020F0502020204030204" pitchFamily="34" charset="0"/>
              </a:rPr>
              <a:t>0.725 </a:t>
            </a:r>
            <a:r>
              <a:rPr lang="ja-JP" altLang="en-US" sz="1400">
                <a:latin typeface="Times" pitchFamily="2" charset="0"/>
                <a:ea typeface="HGMaruGothicMPRO" panose="020F0600000000000000" pitchFamily="34" charset="-128"/>
                <a:cs typeface="Calibri" panose="020F0502020204030204" pitchFamily="34" charset="0"/>
              </a:rPr>
              <a:t>* Weight</a:t>
            </a:r>
            <a:r>
              <a:rPr lang="ja-JP" altLang="en-US" sz="1400" baseline="30000">
                <a:latin typeface="Times" pitchFamily="2" charset="0"/>
                <a:ea typeface="HGMaruGothicMPRO" panose="020F0600000000000000" pitchFamily="34" charset="-128"/>
                <a:cs typeface="Calibri" panose="020F0502020204030204" pitchFamily="34" charset="0"/>
              </a:rPr>
              <a:t>0.425</a:t>
            </a:r>
            <a:r>
              <a:rPr lang="en-US" altLang="ja-JP" sz="1400" dirty="0">
                <a:latin typeface="Times" pitchFamily="2" charset="0"/>
                <a:ea typeface="HGMaruGothicMPRO" panose="020F0600000000000000" pitchFamily="34" charset="-128"/>
                <a:cs typeface="Calibri" panose="020F0502020204030204" pitchFamily="34" charset="0"/>
              </a:rPr>
              <a:t> and </a:t>
            </a:r>
            <a:r>
              <a:rPr lang="en-US" altLang="ja-JP" sz="1400" dirty="0">
                <a:latin typeface="Times" pitchFamily="2" charset="0"/>
                <a:ea typeface="HGMaruGothicMPRO" panose="020F0600000000000000" pitchFamily="34" charset="-128"/>
              </a:rPr>
              <a:t>Weight (kg) *  </a:t>
            </a:r>
            <a:r>
              <a:rPr lang="ja-JP" altLang="en-US" sz="1400">
                <a:latin typeface="Times" pitchFamily="2" charset="0"/>
                <a:ea typeface="HGMaruGothicMPRO" panose="020F0600000000000000" pitchFamily="34" charset="-128"/>
              </a:rPr>
              <a:t>Height</a:t>
            </a:r>
            <a:r>
              <a:rPr lang="en-US" altLang="ja-JP" sz="1400" dirty="0">
                <a:latin typeface="Times" pitchFamily="2" charset="0"/>
                <a:ea typeface="HGMaruGothicMPRO" panose="020F0600000000000000" pitchFamily="34" charset="-128"/>
              </a:rPr>
              <a:t>(m)</a:t>
            </a:r>
            <a:r>
              <a:rPr lang="en-US" altLang="ja-JP" sz="1400" baseline="30000" dirty="0">
                <a:latin typeface="Times" pitchFamily="2" charset="0"/>
                <a:ea typeface="HGMaruGothicMPRO" panose="020F0600000000000000" pitchFamily="34" charset="-128"/>
              </a:rPr>
              <a:t>2</a:t>
            </a:r>
            <a:r>
              <a:rPr lang="ja-JP" altLang="en-US" sz="1400" baseline="30000">
                <a:latin typeface="Times" pitchFamily="2" charset="0"/>
                <a:ea typeface="HGMaruGothicMPRO" panose="020F0600000000000000" pitchFamily="34" charset="-128"/>
              </a:rPr>
              <a:t> </a:t>
            </a:r>
            <a:r>
              <a:rPr lang="en-US" altLang="ja-JP" sz="1400" dirty="0">
                <a:latin typeface="Times" pitchFamily="2" charset="0"/>
                <a:ea typeface="HGMaruGothicMPRO" panose="020F0600000000000000" pitchFamily="34" charset="-128"/>
              </a:rPr>
              <a:t>, respectively.</a:t>
            </a:r>
          </a:p>
        </p:txBody>
      </p:sp>
    </p:spTree>
    <p:extLst>
      <p:ext uri="{BB962C8B-B14F-4D97-AF65-F5344CB8AC3E}">
        <p14:creationId xmlns:p14="http://schemas.microsoft.com/office/powerpoint/2010/main" val="30037246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8F669130-3729-D949-930B-1FFC26B4345F}"/>
              </a:ext>
            </a:extLst>
          </p:cNvPr>
          <p:cNvGrpSpPr/>
          <p:nvPr/>
        </p:nvGrpSpPr>
        <p:grpSpPr>
          <a:xfrm>
            <a:off x="6591221" y="4769906"/>
            <a:ext cx="3217161" cy="1949718"/>
            <a:chOff x="6679657" y="615186"/>
            <a:chExt cx="3217161" cy="1949718"/>
          </a:xfrm>
        </p:grpSpPr>
        <p:pic>
          <p:nvPicPr>
            <p:cNvPr id="131" name="図 130">
              <a:extLst>
                <a:ext uri="{FF2B5EF4-FFF2-40B4-BE49-F238E27FC236}">
                  <a16:creationId xmlns:a16="http://schemas.microsoft.com/office/drawing/2014/main" id="{4C3049D5-E466-4548-92DE-17F5CBAEFB5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728781" y="821577"/>
              <a:ext cx="1599311" cy="1599311"/>
            </a:xfrm>
            <a:prstGeom prst="rect">
              <a:avLst/>
            </a:prstGeom>
          </p:spPr>
        </p:pic>
        <p:pic>
          <p:nvPicPr>
            <p:cNvPr id="134" name="図 133">
              <a:extLst>
                <a:ext uri="{FF2B5EF4-FFF2-40B4-BE49-F238E27FC236}">
                  <a16:creationId xmlns:a16="http://schemas.microsoft.com/office/drawing/2014/main" id="{28713DD3-582B-CE4A-BD4B-E882937450E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294316" y="816415"/>
              <a:ext cx="1602502" cy="1602502"/>
            </a:xfrm>
            <a:prstGeom prst="rect">
              <a:avLst/>
            </a:prstGeom>
          </p:spPr>
        </p:pic>
        <p:sp>
          <p:nvSpPr>
            <p:cNvPr id="95" name="テキスト ボックス 94">
              <a:extLst>
                <a:ext uri="{FF2B5EF4-FFF2-40B4-BE49-F238E27FC236}">
                  <a16:creationId xmlns:a16="http://schemas.microsoft.com/office/drawing/2014/main" id="{E98FB855-A80C-2A45-8533-4EB596B3BEE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367334" y="2398263"/>
              <a:ext cx="507111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>
                  <a:latin typeface="Times" pitchFamily="2" charset="0"/>
                  <a:ea typeface="HG丸ｺﾞｼｯｸM-PRO" charset="-128"/>
                </a:rPr>
                <a:t>P=0.35</a:t>
              </a:r>
            </a:p>
          </p:txBody>
        </p:sp>
        <p:sp>
          <p:nvSpPr>
            <p:cNvPr id="96" name="テキスト ボックス 95">
              <a:extLst>
                <a:ext uri="{FF2B5EF4-FFF2-40B4-BE49-F238E27FC236}">
                  <a16:creationId xmlns:a16="http://schemas.microsoft.com/office/drawing/2014/main" id="{7D89DF5D-3737-0D44-9DBE-F31C7EFA7AE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930790" y="2408275"/>
              <a:ext cx="580433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>
                  <a:latin typeface="Times" pitchFamily="2" charset="0"/>
                  <a:ea typeface="HG丸ｺﾞｼｯｸM-PRO" charset="-128"/>
                </a:rPr>
                <a:t>P=0.20</a:t>
              </a:r>
            </a:p>
          </p:txBody>
        </p:sp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85866CAF-8895-C044-941B-4467DDB519C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597422" y="615186"/>
              <a:ext cx="1388025" cy="17759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/>
              <a:r>
                <a:rPr lang="en-US" altLang="ja-JP" sz="1400" dirty="0">
                  <a:latin typeface="Times" pitchFamily="2" charset="0"/>
                  <a:ea typeface="HG丸ｺﾞｼｯｸM-PRO" charset="-128"/>
                </a:rPr>
                <a:t>Thrombocytopenia</a:t>
              </a:r>
            </a:p>
          </p:txBody>
        </p:sp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D1D0FC24-FA24-0C4B-AEB0-0EC285BBAA2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276342" y="841788"/>
              <a:ext cx="756133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 err="1">
                  <a:latin typeface="Times" pitchFamily="2" charset="0"/>
                  <a:ea typeface="HG丸ｺﾞｼｯｸM-PRO" charset="-128"/>
                </a:rPr>
                <a:t>Osimertinib</a:t>
              </a:r>
              <a:endParaRPr lang="en-US" altLang="ja-JP" sz="1000" dirty="0">
                <a:latin typeface="Times" pitchFamily="2" charset="0"/>
                <a:ea typeface="HG丸ｺﾞｼｯｸM-PRO" charset="-128"/>
              </a:endParaRPr>
            </a:p>
          </p:txBody>
        </p:sp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id="{B756FBA6-F433-8F48-AB6D-21D65B1EC78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961635" y="837649"/>
              <a:ext cx="498569" cy="12575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>
                  <a:latin typeface="Times" pitchFamily="2" charset="0"/>
                  <a:ea typeface="HG丸ｺﾞｼｯｸM-PRO" charset="-128"/>
                </a:rPr>
                <a:t>AZ5104</a:t>
              </a:r>
            </a:p>
          </p:txBody>
        </p:sp>
        <p:sp>
          <p:nvSpPr>
            <p:cNvPr id="101" name="正方形/長方形 100">
              <a:extLst>
                <a:ext uri="{FF2B5EF4-FFF2-40B4-BE49-F238E27FC236}">
                  <a16:creationId xmlns:a16="http://schemas.microsoft.com/office/drawing/2014/main" id="{52CEDC00-3E01-214E-9359-877A48BD117B}"/>
                </a:ext>
              </a:extLst>
            </p:cNvPr>
            <p:cNvSpPr/>
            <p:nvPr/>
          </p:nvSpPr>
          <p:spPr>
            <a:xfrm>
              <a:off x="6858368" y="2196125"/>
              <a:ext cx="137002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" altLang="ja-JP" sz="800" dirty="0">
                  <a:latin typeface="Times" pitchFamily="2" charset="0"/>
                </a:rPr>
                <a:t>Non-occurrence   </a:t>
              </a:r>
              <a:r>
                <a:rPr lang="en" altLang="ja-JP" sz="800" dirty="0" err="1">
                  <a:latin typeface="Times" pitchFamily="2" charset="0"/>
                </a:rPr>
                <a:t>Occurence</a:t>
              </a:r>
              <a:endParaRPr lang="ja-JP" altLang="en-US" sz="800">
                <a:latin typeface="Times" pitchFamily="2" charset="0"/>
              </a:endParaRPr>
            </a:p>
          </p:txBody>
        </p:sp>
        <p:cxnSp>
          <p:nvCxnSpPr>
            <p:cNvPr id="102" name="直線コネクタ 101">
              <a:extLst>
                <a:ext uri="{FF2B5EF4-FFF2-40B4-BE49-F238E27FC236}">
                  <a16:creationId xmlns:a16="http://schemas.microsoft.com/office/drawing/2014/main" id="{9F8FC627-C7C8-4247-BD4A-3BE71B93EB1F}"/>
                </a:ext>
              </a:extLst>
            </p:cNvPr>
            <p:cNvCxnSpPr>
              <a:cxnSpLocks/>
            </p:cNvCxnSpPr>
            <p:nvPr/>
          </p:nvCxnSpPr>
          <p:spPr>
            <a:xfrm>
              <a:off x="6905307" y="837737"/>
              <a:ext cx="28188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正方形/長方形 102">
              <a:extLst>
                <a:ext uri="{FF2B5EF4-FFF2-40B4-BE49-F238E27FC236}">
                  <a16:creationId xmlns:a16="http://schemas.microsoft.com/office/drawing/2014/main" id="{1CA52797-73FF-7249-9CBD-ECD89D2D900F}"/>
                </a:ext>
              </a:extLst>
            </p:cNvPr>
            <p:cNvSpPr/>
            <p:nvPr/>
          </p:nvSpPr>
          <p:spPr>
            <a:xfrm>
              <a:off x="8296123" y="1537683"/>
              <a:ext cx="80079" cy="1074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" pitchFamily="2" charset="0"/>
              </a:endParaRPr>
            </a:p>
          </p:txBody>
        </p:sp>
        <p:sp>
          <p:nvSpPr>
            <p:cNvPr id="104" name="正方形/長方形 103">
              <a:extLst>
                <a:ext uri="{FF2B5EF4-FFF2-40B4-BE49-F238E27FC236}">
                  <a16:creationId xmlns:a16="http://schemas.microsoft.com/office/drawing/2014/main" id="{CA3589DE-B506-5E47-9E54-81A5559D2EA1}"/>
                </a:ext>
              </a:extLst>
            </p:cNvPr>
            <p:cNvSpPr/>
            <p:nvPr/>
          </p:nvSpPr>
          <p:spPr>
            <a:xfrm>
              <a:off x="6712146" y="1537682"/>
              <a:ext cx="80079" cy="1074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" pitchFamily="2" charset="0"/>
              </a:endParaRPr>
            </a:p>
          </p:txBody>
        </p: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B2D56C85-0313-554C-8001-BDF60A137E7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6378835" y="1441031"/>
              <a:ext cx="758274" cy="1566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800" dirty="0">
                  <a:latin typeface="Times" pitchFamily="2" charset="0"/>
                  <a:ea typeface="HG丸ｺﾞｼｯｸM-PRO" charset="-128"/>
                </a:rPr>
                <a:t>trough ng/ml</a:t>
              </a:r>
            </a:p>
          </p:txBody>
        </p: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143939CF-4ACD-EF4D-AB0A-951A4A63C76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7966301" y="1441030"/>
              <a:ext cx="758276" cy="1566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800" dirty="0">
                  <a:latin typeface="Times" pitchFamily="2" charset="0"/>
                  <a:ea typeface="HG丸ｺﾞｼｯｸM-PRO" charset="-128"/>
                </a:rPr>
                <a:t>trough ng/ml</a:t>
              </a:r>
            </a:p>
          </p:txBody>
        </p:sp>
        <p:sp>
          <p:nvSpPr>
            <p:cNvPr id="107" name="正方形/長方形 106">
              <a:extLst>
                <a:ext uri="{FF2B5EF4-FFF2-40B4-BE49-F238E27FC236}">
                  <a16:creationId xmlns:a16="http://schemas.microsoft.com/office/drawing/2014/main" id="{FB0107E6-2619-AC45-BD45-6D1FE879D44E}"/>
                </a:ext>
              </a:extLst>
            </p:cNvPr>
            <p:cNvSpPr/>
            <p:nvPr/>
          </p:nvSpPr>
          <p:spPr>
            <a:xfrm>
              <a:off x="8415600" y="2192831"/>
              <a:ext cx="137002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" altLang="ja-JP" sz="800" dirty="0">
                  <a:latin typeface="Times" pitchFamily="2" charset="0"/>
                </a:rPr>
                <a:t>Non-occurrence   </a:t>
              </a:r>
              <a:r>
                <a:rPr lang="en" altLang="ja-JP" sz="800" dirty="0" err="1">
                  <a:latin typeface="Times" pitchFamily="2" charset="0"/>
                </a:rPr>
                <a:t>Occurence</a:t>
              </a:r>
              <a:endParaRPr lang="ja-JP" altLang="en-US" sz="800">
                <a:latin typeface="Times" pitchFamily="2" charset="0"/>
              </a:endParaRPr>
            </a:p>
          </p:txBody>
        </p:sp>
      </p:grp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04CB2B7C-1149-EC43-85B6-55282BE4EED5}"/>
              </a:ext>
            </a:extLst>
          </p:cNvPr>
          <p:cNvGrpSpPr/>
          <p:nvPr/>
        </p:nvGrpSpPr>
        <p:grpSpPr>
          <a:xfrm>
            <a:off x="175679" y="648914"/>
            <a:ext cx="3229179" cy="1928752"/>
            <a:chOff x="3376062" y="4775198"/>
            <a:chExt cx="3229179" cy="1928752"/>
          </a:xfrm>
        </p:grpSpPr>
        <p:pic>
          <p:nvPicPr>
            <p:cNvPr id="10" name="図 9">
              <a:extLst>
                <a:ext uri="{FF2B5EF4-FFF2-40B4-BE49-F238E27FC236}">
                  <a16:creationId xmlns:a16="http://schemas.microsoft.com/office/drawing/2014/main" id="{80DB4B54-4E4D-DE4D-A457-483EB35AA61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420788" y="4946751"/>
              <a:ext cx="1616947" cy="1616947"/>
            </a:xfrm>
            <a:prstGeom prst="rect">
              <a:avLst/>
            </a:prstGeom>
          </p:spPr>
        </p:pic>
        <p:pic>
          <p:nvPicPr>
            <p:cNvPr id="41" name="図 40">
              <a:extLst>
                <a:ext uri="{FF2B5EF4-FFF2-40B4-BE49-F238E27FC236}">
                  <a16:creationId xmlns:a16="http://schemas.microsoft.com/office/drawing/2014/main" id="{9F806078-F02E-6849-8B44-7CD99946391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989970" y="4942975"/>
              <a:ext cx="1615271" cy="1615271"/>
            </a:xfrm>
            <a:prstGeom prst="rect">
              <a:avLst/>
            </a:prstGeom>
          </p:spPr>
        </p:pic>
        <p:sp>
          <p:nvSpPr>
            <p:cNvPr id="200" name="テキスト ボックス 199">
              <a:extLst>
                <a:ext uri="{FF2B5EF4-FFF2-40B4-BE49-F238E27FC236}">
                  <a16:creationId xmlns:a16="http://schemas.microsoft.com/office/drawing/2014/main" id="{30BF2E73-A3B1-7E47-A74A-E7565D2F2AF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63739" y="6537309"/>
              <a:ext cx="507111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>
                  <a:latin typeface="Times" pitchFamily="2" charset="0"/>
                  <a:ea typeface="HG丸ｺﾞｼｯｸM-PRO" charset="-128"/>
                </a:rPr>
                <a:t>P=0.74</a:t>
              </a:r>
            </a:p>
          </p:txBody>
        </p:sp>
        <p:sp>
          <p:nvSpPr>
            <p:cNvPr id="201" name="テキスト ボックス 200">
              <a:extLst>
                <a:ext uri="{FF2B5EF4-FFF2-40B4-BE49-F238E27FC236}">
                  <a16:creationId xmlns:a16="http://schemas.microsoft.com/office/drawing/2014/main" id="{2BC03BCC-6247-B04F-BD0E-3FB1CFCCF07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27195" y="6547321"/>
              <a:ext cx="580433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>
                  <a:latin typeface="Times" pitchFamily="2" charset="0"/>
                  <a:ea typeface="HG丸ｺﾞｼｯｸM-PRO" charset="-128"/>
                </a:rPr>
                <a:t>P=0.71</a:t>
              </a:r>
            </a:p>
          </p:txBody>
        </p:sp>
        <p:sp>
          <p:nvSpPr>
            <p:cNvPr id="203" name="テキスト ボックス 202">
              <a:extLst>
                <a:ext uri="{FF2B5EF4-FFF2-40B4-BE49-F238E27FC236}">
                  <a16:creationId xmlns:a16="http://schemas.microsoft.com/office/drawing/2014/main" id="{FB072950-BB58-B042-B423-BD66F295BEE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93800" y="4775198"/>
              <a:ext cx="1262787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/>
              <a:r>
                <a:rPr lang="en-US" altLang="ja-JP" sz="1400" dirty="0">
                  <a:latin typeface="Times" pitchFamily="2" charset="0"/>
                  <a:ea typeface="HG丸ｺﾞｼｯｸM-PRO" charset="-128"/>
                </a:rPr>
                <a:t>Paronychia</a:t>
              </a:r>
            </a:p>
          </p:txBody>
        </p:sp>
        <p:sp>
          <p:nvSpPr>
            <p:cNvPr id="204" name="テキスト ボックス 203">
              <a:extLst>
                <a:ext uri="{FF2B5EF4-FFF2-40B4-BE49-F238E27FC236}">
                  <a16:creationId xmlns:a16="http://schemas.microsoft.com/office/drawing/2014/main" id="{40941BC2-D768-9148-81E2-7E968755A4C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72747" y="4980834"/>
              <a:ext cx="756133" cy="9463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 err="1">
                  <a:latin typeface="Times" pitchFamily="2" charset="0"/>
                  <a:ea typeface="HG丸ｺﾞｼｯｸM-PRO" charset="-128"/>
                </a:rPr>
                <a:t>Osimertinib</a:t>
              </a:r>
              <a:endParaRPr lang="en-US" altLang="ja-JP" sz="1000" dirty="0">
                <a:latin typeface="Times" pitchFamily="2" charset="0"/>
                <a:ea typeface="HG丸ｺﾞｼｯｸM-PRO" charset="-128"/>
              </a:endParaRPr>
            </a:p>
          </p:txBody>
        </p:sp>
        <p:sp>
          <p:nvSpPr>
            <p:cNvPr id="205" name="テキスト ボックス 204">
              <a:extLst>
                <a:ext uri="{FF2B5EF4-FFF2-40B4-BE49-F238E27FC236}">
                  <a16:creationId xmlns:a16="http://schemas.microsoft.com/office/drawing/2014/main" id="{6F260F37-0F1E-FA4D-9C12-8070B56B6C8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58040" y="4976696"/>
              <a:ext cx="498569" cy="10318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>
                  <a:latin typeface="Times" pitchFamily="2" charset="0"/>
                  <a:ea typeface="HG丸ｺﾞｼｯｸM-PRO" charset="-128"/>
                </a:rPr>
                <a:t>AZ5104</a:t>
              </a:r>
            </a:p>
          </p:txBody>
        </p:sp>
        <p:sp>
          <p:nvSpPr>
            <p:cNvPr id="206" name="正方形/長方形 205">
              <a:extLst>
                <a:ext uri="{FF2B5EF4-FFF2-40B4-BE49-F238E27FC236}">
                  <a16:creationId xmlns:a16="http://schemas.microsoft.com/office/drawing/2014/main" id="{31A14ECD-ABE2-8744-A3AC-A901B3C01597}"/>
                </a:ext>
              </a:extLst>
            </p:cNvPr>
            <p:cNvSpPr/>
            <p:nvPr/>
          </p:nvSpPr>
          <p:spPr>
            <a:xfrm>
              <a:off x="3554773" y="6335171"/>
              <a:ext cx="137002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" altLang="ja-JP" sz="800" dirty="0">
                  <a:latin typeface="Times" pitchFamily="2" charset="0"/>
                </a:rPr>
                <a:t>Non-occurrence   </a:t>
              </a:r>
              <a:r>
                <a:rPr lang="en" altLang="ja-JP" sz="800" dirty="0" err="1">
                  <a:latin typeface="Times" pitchFamily="2" charset="0"/>
                </a:rPr>
                <a:t>Occurence</a:t>
              </a:r>
              <a:endParaRPr lang="ja-JP" altLang="en-US" sz="800">
                <a:latin typeface="Times" pitchFamily="2" charset="0"/>
              </a:endParaRPr>
            </a:p>
          </p:txBody>
        </p:sp>
        <p:cxnSp>
          <p:nvCxnSpPr>
            <p:cNvPr id="207" name="直線コネクタ 206">
              <a:extLst>
                <a:ext uri="{FF2B5EF4-FFF2-40B4-BE49-F238E27FC236}">
                  <a16:creationId xmlns:a16="http://schemas.microsoft.com/office/drawing/2014/main" id="{C8199B7C-6FD1-D846-B7FA-77FDAD90DD12}"/>
                </a:ext>
              </a:extLst>
            </p:cNvPr>
            <p:cNvCxnSpPr>
              <a:cxnSpLocks/>
            </p:cNvCxnSpPr>
            <p:nvPr/>
          </p:nvCxnSpPr>
          <p:spPr>
            <a:xfrm>
              <a:off x="3601712" y="4976783"/>
              <a:ext cx="28188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8" name="正方形/長方形 207">
              <a:extLst>
                <a:ext uri="{FF2B5EF4-FFF2-40B4-BE49-F238E27FC236}">
                  <a16:creationId xmlns:a16="http://schemas.microsoft.com/office/drawing/2014/main" id="{237711AD-5FED-7944-ABF1-4F5CEDDBB89B}"/>
                </a:ext>
              </a:extLst>
            </p:cNvPr>
            <p:cNvSpPr/>
            <p:nvPr/>
          </p:nvSpPr>
          <p:spPr>
            <a:xfrm>
              <a:off x="4992528" y="5676729"/>
              <a:ext cx="80079" cy="1074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" pitchFamily="2" charset="0"/>
              </a:endParaRPr>
            </a:p>
          </p:txBody>
        </p:sp>
        <p:sp>
          <p:nvSpPr>
            <p:cNvPr id="209" name="正方形/長方形 208">
              <a:extLst>
                <a:ext uri="{FF2B5EF4-FFF2-40B4-BE49-F238E27FC236}">
                  <a16:creationId xmlns:a16="http://schemas.microsoft.com/office/drawing/2014/main" id="{6D8D3109-E574-3E4C-ABE3-6EE93940E649}"/>
                </a:ext>
              </a:extLst>
            </p:cNvPr>
            <p:cNvSpPr/>
            <p:nvPr/>
          </p:nvSpPr>
          <p:spPr>
            <a:xfrm>
              <a:off x="3408551" y="5676728"/>
              <a:ext cx="80079" cy="1074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" pitchFamily="2" charset="0"/>
              </a:endParaRPr>
            </a:p>
          </p:txBody>
        </p:sp>
        <p:sp>
          <p:nvSpPr>
            <p:cNvPr id="210" name="テキスト ボックス 209">
              <a:extLst>
                <a:ext uri="{FF2B5EF4-FFF2-40B4-BE49-F238E27FC236}">
                  <a16:creationId xmlns:a16="http://schemas.microsoft.com/office/drawing/2014/main" id="{9EB60D3A-C03D-5446-8423-19CB66BE15C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075240" y="5580077"/>
              <a:ext cx="758274" cy="1566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800" dirty="0">
                  <a:latin typeface="Times" pitchFamily="2" charset="0"/>
                  <a:ea typeface="HG丸ｺﾞｼｯｸM-PRO" charset="-128"/>
                </a:rPr>
                <a:t>trough ng/ml</a:t>
              </a:r>
            </a:p>
          </p:txBody>
        </p:sp>
        <p:sp>
          <p:nvSpPr>
            <p:cNvPr id="211" name="テキスト ボックス 210">
              <a:extLst>
                <a:ext uri="{FF2B5EF4-FFF2-40B4-BE49-F238E27FC236}">
                  <a16:creationId xmlns:a16="http://schemas.microsoft.com/office/drawing/2014/main" id="{A6C1B518-E167-DC4D-BD22-107619DCE83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662706" y="5580076"/>
              <a:ext cx="758276" cy="1566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800" dirty="0">
                  <a:latin typeface="Times" pitchFamily="2" charset="0"/>
                  <a:ea typeface="HG丸ｺﾞｼｯｸM-PRO" charset="-128"/>
                </a:rPr>
                <a:t>trough ng/ml</a:t>
              </a:r>
            </a:p>
          </p:txBody>
        </p:sp>
        <p:sp>
          <p:nvSpPr>
            <p:cNvPr id="212" name="正方形/長方形 211">
              <a:extLst>
                <a:ext uri="{FF2B5EF4-FFF2-40B4-BE49-F238E27FC236}">
                  <a16:creationId xmlns:a16="http://schemas.microsoft.com/office/drawing/2014/main" id="{DBF9C802-89DD-0D4D-8C33-66AE89C5EA54}"/>
                </a:ext>
              </a:extLst>
            </p:cNvPr>
            <p:cNvSpPr/>
            <p:nvPr/>
          </p:nvSpPr>
          <p:spPr>
            <a:xfrm>
              <a:off x="5112005" y="6331877"/>
              <a:ext cx="137002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" altLang="ja-JP" sz="800" dirty="0">
                  <a:latin typeface="Times" pitchFamily="2" charset="0"/>
                </a:rPr>
                <a:t>Non-occurrence   </a:t>
              </a:r>
              <a:r>
                <a:rPr lang="en" altLang="ja-JP" sz="800" dirty="0" err="1">
                  <a:latin typeface="Times" pitchFamily="2" charset="0"/>
                </a:rPr>
                <a:t>Occurence</a:t>
              </a:r>
              <a:endParaRPr lang="ja-JP" altLang="en-US" sz="800">
                <a:latin typeface="Times" pitchFamily="2" charset="0"/>
              </a:endParaRPr>
            </a:p>
          </p:txBody>
        </p:sp>
      </p:grp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02FF56DA-01BA-BA4F-BB44-8A9CF2F7DF0E}"/>
              </a:ext>
            </a:extLst>
          </p:cNvPr>
          <p:cNvGrpSpPr/>
          <p:nvPr/>
        </p:nvGrpSpPr>
        <p:grpSpPr>
          <a:xfrm>
            <a:off x="140520" y="4840406"/>
            <a:ext cx="3234513" cy="1928752"/>
            <a:chOff x="152503" y="4762742"/>
            <a:chExt cx="3234513" cy="1928752"/>
          </a:xfrm>
        </p:grpSpPr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CCEB4EC8-9769-3540-8036-F9A460CF9F1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02188" y="4937627"/>
              <a:ext cx="1617976" cy="1617976"/>
            </a:xfrm>
            <a:prstGeom prst="rect">
              <a:avLst/>
            </a:prstGeom>
          </p:spPr>
        </p:pic>
        <p:pic>
          <p:nvPicPr>
            <p:cNvPr id="35" name="図 34">
              <a:extLst>
                <a:ext uri="{FF2B5EF4-FFF2-40B4-BE49-F238E27FC236}">
                  <a16:creationId xmlns:a16="http://schemas.microsoft.com/office/drawing/2014/main" id="{3D147074-2D1C-6F4B-9034-B9F793786F86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769438" y="4929883"/>
              <a:ext cx="1617578" cy="1617578"/>
            </a:xfrm>
            <a:prstGeom prst="rect">
              <a:avLst/>
            </a:prstGeom>
          </p:spPr>
        </p:pic>
        <p:sp>
          <p:nvSpPr>
            <p:cNvPr id="185" name="テキスト ボックス 184">
              <a:extLst>
                <a:ext uri="{FF2B5EF4-FFF2-40B4-BE49-F238E27FC236}">
                  <a16:creationId xmlns:a16="http://schemas.microsoft.com/office/drawing/2014/main" id="{CD331AB8-72FE-1C4E-966E-F11EB49B77C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40180" y="6524853"/>
              <a:ext cx="507111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>
                  <a:latin typeface="Times" pitchFamily="2" charset="0"/>
                  <a:ea typeface="HG丸ｺﾞｼｯｸM-PRO" charset="-128"/>
                </a:rPr>
                <a:t>P=0.63</a:t>
              </a:r>
            </a:p>
          </p:txBody>
        </p:sp>
        <p:sp>
          <p:nvSpPr>
            <p:cNvPr id="186" name="テキスト ボックス 185">
              <a:extLst>
                <a:ext uri="{FF2B5EF4-FFF2-40B4-BE49-F238E27FC236}">
                  <a16:creationId xmlns:a16="http://schemas.microsoft.com/office/drawing/2014/main" id="{7EF0ABF1-C6D8-2E43-A838-621722D6F22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03636" y="6534865"/>
              <a:ext cx="580433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>
                  <a:latin typeface="Times" pitchFamily="2" charset="0"/>
                  <a:ea typeface="HG丸ｺﾞｼｯｸM-PRO" charset="-128"/>
                </a:rPr>
                <a:t>P=0.57</a:t>
              </a:r>
            </a:p>
          </p:txBody>
        </p:sp>
        <p:sp>
          <p:nvSpPr>
            <p:cNvPr id="188" name="テキスト ボックス 187">
              <a:extLst>
                <a:ext uri="{FF2B5EF4-FFF2-40B4-BE49-F238E27FC236}">
                  <a16:creationId xmlns:a16="http://schemas.microsoft.com/office/drawing/2014/main" id="{8D7446DF-9575-A242-A3C3-775BFC6B196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70241" y="4762742"/>
              <a:ext cx="1262787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/>
              <a:r>
                <a:rPr lang="en-US" altLang="ja-JP" sz="1400" dirty="0">
                  <a:latin typeface="Times" pitchFamily="2" charset="0"/>
                  <a:ea typeface="HG丸ｺﾞｼｯｸM-PRO" charset="-128"/>
                </a:rPr>
                <a:t>Liver dysfunction</a:t>
              </a:r>
            </a:p>
          </p:txBody>
        </p:sp>
        <p:sp>
          <p:nvSpPr>
            <p:cNvPr id="189" name="テキスト ボックス 188">
              <a:extLst>
                <a:ext uri="{FF2B5EF4-FFF2-40B4-BE49-F238E27FC236}">
                  <a16:creationId xmlns:a16="http://schemas.microsoft.com/office/drawing/2014/main" id="{8DD4CAD7-EC5F-1F4E-8CCC-E8538699182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49188" y="4968379"/>
              <a:ext cx="756133" cy="11149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 err="1">
                  <a:latin typeface="Times" pitchFamily="2" charset="0"/>
                  <a:ea typeface="HG丸ｺﾞｼｯｸM-PRO" charset="-128"/>
                </a:rPr>
                <a:t>Osimertinib</a:t>
              </a:r>
              <a:endParaRPr lang="en-US" altLang="ja-JP" sz="1000" dirty="0">
                <a:latin typeface="Times" pitchFamily="2" charset="0"/>
                <a:ea typeface="HG丸ｺﾞｼｯｸM-PRO" charset="-128"/>
              </a:endParaRPr>
            </a:p>
          </p:txBody>
        </p:sp>
        <p:sp>
          <p:nvSpPr>
            <p:cNvPr id="190" name="テキスト ボックス 189">
              <a:extLst>
                <a:ext uri="{FF2B5EF4-FFF2-40B4-BE49-F238E27FC236}">
                  <a16:creationId xmlns:a16="http://schemas.microsoft.com/office/drawing/2014/main" id="{9F8E241E-7716-1D46-989C-D4DC957ABF0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34481" y="4964240"/>
              <a:ext cx="498569" cy="11563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>
                  <a:latin typeface="Times" pitchFamily="2" charset="0"/>
                  <a:ea typeface="HG丸ｺﾞｼｯｸM-PRO" charset="-128"/>
                </a:rPr>
                <a:t>AZ5104</a:t>
              </a:r>
            </a:p>
          </p:txBody>
        </p:sp>
        <p:sp>
          <p:nvSpPr>
            <p:cNvPr id="191" name="正方形/長方形 190">
              <a:extLst>
                <a:ext uri="{FF2B5EF4-FFF2-40B4-BE49-F238E27FC236}">
                  <a16:creationId xmlns:a16="http://schemas.microsoft.com/office/drawing/2014/main" id="{AE7E2E0C-D769-084D-909D-7C18E485C560}"/>
                </a:ext>
              </a:extLst>
            </p:cNvPr>
            <p:cNvSpPr/>
            <p:nvPr/>
          </p:nvSpPr>
          <p:spPr>
            <a:xfrm>
              <a:off x="331214" y="6322715"/>
              <a:ext cx="137002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" altLang="ja-JP" sz="800" dirty="0">
                  <a:latin typeface="Times" pitchFamily="2" charset="0"/>
                </a:rPr>
                <a:t>Non-occurrence   </a:t>
              </a:r>
              <a:r>
                <a:rPr lang="en" altLang="ja-JP" sz="800" dirty="0" err="1">
                  <a:latin typeface="Times" pitchFamily="2" charset="0"/>
                </a:rPr>
                <a:t>Occurence</a:t>
              </a:r>
              <a:endParaRPr lang="ja-JP" altLang="en-US" sz="800">
                <a:latin typeface="Times" pitchFamily="2" charset="0"/>
              </a:endParaRPr>
            </a:p>
          </p:txBody>
        </p:sp>
        <p:cxnSp>
          <p:nvCxnSpPr>
            <p:cNvPr id="192" name="直線コネクタ 191">
              <a:extLst>
                <a:ext uri="{FF2B5EF4-FFF2-40B4-BE49-F238E27FC236}">
                  <a16:creationId xmlns:a16="http://schemas.microsoft.com/office/drawing/2014/main" id="{FA4DA99A-1A33-1E41-9091-C9FA5310E028}"/>
                </a:ext>
              </a:extLst>
            </p:cNvPr>
            <p:cNvCxnSpPr>
              <a:cxnSpLocks/>
            </p:cNvCxnSpPr>
            <p:nvPr/>
          </p:nvCxnSpPr>
          <p:spPr>
            <a:xfrm>
              <a:off x="378153" y="4964327"/>
              <a:ext cx="28188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3" name="正方形/長方形 192">
              <a:extLst>
                <a:ext uri="{FF2B5EF4-FFF2-40B4-BE49-F238E27FC236}">
                  <a16:creationId xmlns:a16="http://schemas.microsoft.com/office/drawing/2014/main" id="{20024DA9-0E4F-B64C-93CF-19501EAB61E5}"/>
                </a:ext>
              </a:extLst>
            </p:cNvPr>
            <p:cNvSpPr/>
            <p:nvPr/>
          </p:nvSpPr>
          <p:spPr>
            <a:xfrm>
              <a:off x="1768969" y="5664273"/>
              <a:ext cx="80079" cy="1074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" pitchFamily="2" charset="0"/>
              </a:endParaRPr>
            </a:p>
          </p:txBody>
        </p:sp>
        <p:sp>
          <p:nvSpPr>
            <p:cNvPr id="194" name="正方形/長方形 193">
              <a:extLst>
                <a:ext uri="{FF2B5EF4-FFF2-40B4-BE49-F238E27FC236}">
                  <a16:creationId xmlns:a16="http://schemas.microsoft.com/office/drawing/2014/main" id="{DE578F0D-1E4B-7B46-A890-B6E078DA75F4}"/>
                </a:ext>
              </a:extLst>
            </p:cNvPr>
            <p:cNvSpPr/>
            <p:nvPr/>
          </p:nvSpPr>
          <p:spPr>
            <a:xfrm>
              <a:off x="184992" y="5664272"/>
              <a:ext cx="80079" cy="1074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" pitchFamily="2" charset="0"/>
              </a:endParaRPr>
            </a:p>
          </p:txBody>
        </p:sp>
        <p:sp>
          <p:nvSpPr>
            <p:cNvPr id="195" name="テキスト ボックス 194">
              <a:extLst>
                <a:ext uri="{FF2B5EF4-FFF2-40B4-BE49-F238E27FC236}">
                  <a16:creationId xmlns:a16="http://schemas.microsoft.com/office/drawing/2014/main" id="{D1305CFD-3A0B-6B43-81F9-D03C6A42993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-148319" y="5567621"/>
              <a:ext cx="758274" cy="1566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800" dirty="0">
                  <a:latin typeface="Times" pitchFamily="2" charset="0"/>
                  <a:ea typeface="HG丸ｺﾞｼｯｸM-PRO" charset="-128"/>
                </a:rPr>
                <a:t>trough ng/ml</a:t>
              </a:r>
            </a:p>
          </p:txBody>
        </p:sp>
        <p:sp>
          <p:nvSpPr>
            <p:cNvPr id="196" name="テキスト ボックス 195">
              <a:extLst>
                <a:ext uri="{FF2B5EF4-FFF2-40B4-BE49-F238E27FC236}">
                  <a16:creationId xmlns:a16="http://schemas.microsoft.com/office/drawing/2014/main" id="{985B1E6B-1441-D34C-ADF6-AB280FF337D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439147" y="5567620"/>
              <a:ext cx="758276" cy="1566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800" dirty="0">
                  <a:latin typeface="Times" pitchFamily="2" charset="0"/>
                  <a:ea typeface="HG丸ｺﾞｼｯｸM-PRO" charset="-128"/>
                </a:rPr>
                <a:t>trough ng/ml</a:t>
              </a:r>
            </a:p>
          </p:txBody>
        </p:sp>
        <p:sp>
          <p:nvSpPr>
            <p:cNvPr id="197" name="正方形/長方形 196">
              <a:extLst>
                <a:ext uri="{FF2B5EF4-FFF2-40B4-BE49-F238E27FC236}">
                  <a16:creationId xmlns:a16="http://schemas.microsoft.com/office/drawing/2014/main" id="{B410513C-84FB-5848-BB82-34F7898176C7}"/>
                </a:ext>
              </a:extLst>
            </p:cNvPr>
            <p:cNvSpPr/>
            <p:nvPr/>
          </p:nvSpPr>
          <p:spPr>
            <a:xfrm>
              <a:off x="1888446" y="6319421"/>
              <a:ext cx="137002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" altLang="ja-JP" sz="800" dirty="0">
                  <a:latin typeface="Times" pitchFamily="2" charset="0"/>
                </a:rPr>
                <a:t>Non-occurrence   </a:t>
              </a:r>
              <a:r>
                <a:rPr lang="en" altLang="ja-JP" sz="800" dirty="0" err="1">
                  <a:latin typeface="Times" pitchFamily="2" charset="0"/>
                </a:rPr>
                <a:t>Occurence</a:t>
              </a:r>
              <a:endParaRPr lang="ja-JP" altLang="en-US" sz="800">
                <a:latin typeface="Times" pitchFamily="2" charset="0"/>
              </a:endParaRPr>
            </a:p>
          </p:txBody>
        </p: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D60BEA20-61C9-D54F-B43B-D717EF58DA6C}"/>
              </a:ext>
            </a:extLst>
          </p:cNvPr>
          <p:cNvGrpSpPr/>
          <p:nvPr/>
        </p:nvGrpSpPr>
        <p:grpSpPr>
          <a:xfrm>
            <a:off x="6591221" y="2718683"/>
            <a:ext cx="3231200" cy="1928752"/>
            <a:chOff x="6591455" y="2795645"/>
            <a:chExt cx="3231200" cy="1928752"/>
          </a:xfrm>
        </p:grpSpPr>
        <p:pic>
          <p:nvPicPr>
            <p:cNvPr id="9" name="図 8">
              <a:extLst>
                <a:ext uri="{FF2B5EF4-FFF2-40B4-BE49-F238E27FC236}">
                  <a16:creationId xmlns:a16="http://schemas.microsoft.com/office/drawing/2014/main" id="{91F263CB-4A52-A947-AE1F-0E4C821F5016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640421" y="2972064"/>
              <a:ext cx="1614829" cy="1614829"/>
            </a:xfrm>
            <a:prstGeom prst="rect">
              <a:avLst/>
            </a:prstGeom>
          </p:spPr>
        </p:pic>
        <p:pic>
          <p:nvPicPr>
            <p:cNvPr id="47" name="図 46">
              <a:extLst>
                <a:ext uri="{FF2B5EF4-FFF2-40B4-BE49-F238E27FC236}">
                  <a16:creationId xmlns:a16="http://schemas.microsoft.com/office/drawing/2014/main" id="{50609C27-711F-0047-8EB9-0A00AAF98032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8209045" y="2967122"/>
              <a:ext cx="1613610" cy="1613610"/>
            </a:xfrm>
            <a:prstGeom prst="rect">
              <a:avLst/>
            </a:prstGeom>
          </p:spPr>
        </p:pic>
        <p:sp>
          <p:nvSpPr>
            <p:cNvPr id="215" name="テキスト ボックス 214">
              <a:extLst>
                <a:ext uri="{FF2B5EF4-FFF2-40B4-BE49-F238E27FC236}">
                  <a16:creationId xmlns:a16="http://schemas.microsoft.com/office/drawing/2014/main" id="{90D46700-1D72-3D4F-B5C1-B629C72DAB1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279132" y="4557756"/>
              <a:ext cx="507111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>
                  <a:latin typeface="Times" pitchFamily="2" charset="0"/>
                  <a:ea typeface="HG丸ｺﾞｼｯｸM-PRO" charset="-128"/>
                </a:rPr>
                <a:t>P=0.32</a:t>
              </a:r>
            </a:p>
          </p:txBody>
        </p:sp>
        <p:sp>
          <p:nvSpPr>
            <p:cNvPr id="216" name="テキスト ボックス 215">
              <a:extLst>
                <a:ext uri="{FF2B5EF4-FFF2-40B4-BE49-F238E27FC236}">
                  <a16:creationId xmlns:a16="http://schemas.microsoft.com/office/drawing/2014/main" id="{F92E5C6A-B071-0743-A2A3-3226722D27B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842588" y="4567768"/>
              <a:ext cx="580433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>
                  <a:latin typeface="Times" pitchFamily="2" charset="0"/>
                  <a:ea typeface="HG丸ｺﾞｼｯｸM-PRO" charset="-128"/>
                </a:rPr>
                <a:t>P=0.64</a:t>
              </a:r>
            </a:p>
          </p:txBody>
        </p:sp>
        <p:sp>
          <p:nvSpPr>
            <p:cNvPr id="218" name="テキスト ボックス 217">
              <a:extLst>
                <a:ext uri="{FF2B5EF4-FFF2-40B4-BE49-F238E27FC236}">
                  <a16:creationId xmlns:a16="http://schemas.microsoft.com/office/drawing/2014/main" id="{A8AE425C-4E26-024A-9F96-6882BE50136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609193" y="2795645"/>
              <a:ext cx="1262787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/>
              <a:r>
                <a:rPr lang="en-US" altLang="ja-JP" sz="1400" dirty="0">
                  <a:latin typeface="Times" pitchFamily="2" charset="0"/>
                  <a:ea typeface="HG丸ｺﾞｼｯｸM-PRO" charset="-128"/>
                </a:rPr>
                <a:t>Neutropenia</a:t>
              </a:r>
            </a:p>
          </p:txBody>
        </p:sp>
        <p:sp>
          <p:nvSpPr>
            <p:cNvPr id="219" name="テキスト ボックス 218">
              <a:extLst>
                <a:ext uri="{FF2B5EF4-FFF2-40B4-BE49-F238E27FC236}">
                  <a16:creationId xmlns:a16="http://schemas.microsoft.com/office/drawing/2014/main" id="{26614D40-A5FE-2247-B3A3-5E12C21422B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188140" y="3001282"/>
              <a:ext cx="756133" cy="10923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 err="1">
                  <a:latin typeface="Times" pitchFamily="2" charset="0"/>
                  <a:ea typeface="HG丸ｺﾞｼｯｸM-PRO" charset="-128"/>
                </a:rPr>
                <a:t>Osimertinib</a:t>
              </a:r>
              <a:endParaRPr lang="en-US" altLang="ja-JP" sz="1000" dirty="0">
                <a:latin typeface="Times" pitchFamily="2" charset="0"/>
                <a:ea typeface="HG丸ｺﾞｼｯｸM-PRO" charset="-128"/>
              </a:endParaRPr>
            </a:p>
          </p:txBody>
        </p:sp>
        <p:sp>
          <p:nvSpPr>
            <p:cNvPr id="220" name="テキスト ボックス 219">
              <a:extLst>
                <a:ext uri="{FF2B5EF4-FFF2-40B4-BE49-F238E27FC236}">
                  <a16:creationId xmlns:a16="http://schemas.microsoft.com/office/drawing/2014/main" id="{1A488128-E17A-2449-88EF-CBE810B3761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873433" y="2997142"/>
              <a:ext cx="498569" cy="11337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>
                  <a:latin typeface="Times" pitchFamily="2" charset="0"/>
                  <a:ea typeface="HG丸ｺﾞｼｯｸM-PRO" charset="-128"/>
                </a:rPr>
                <a:t>AZ5104</a:t>
              </a:r>
            </a:p>
          </p:txBody>
        </p:sp>
        <p:sp>
          <p:nvSpPr>
            <p:cNvPr id="221" name="正方形/長方形 220">
              <a:extLst>
                <a:ext uri="{FF2B5EF4-FFF2-40B4-BE49-F238E27FC236}">
                  <a16:creationId xmlns:a16="http://schemas.microsoft.com/office/drawing/2014/main" id="{F0402520-3831-124E-9FEC-A2EFF9DC9F4B}"/>
                </a:ext>
              </a:extLst>
            </p:cNvPr>
            <p:cNvSpPr/>
            <p:nvPr/>
          </p:nvSpPr>
          <p:spPr>
            <a:xfrm>
              <a:off x="6770166" y="4355618"/>
              <a:ext cx="137002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" altLang="ja-JP" sz="800" dirty="0">
                  <a:latin typeface="Times" pitchFamily="2" charset="0"/>
                </a:rPr>
                <a:t>Non-occurrence   </a:t>
              </a:r>
              <a:r>
                <a:rPr lang="en" altLang="ja-JP" sz="800" dirty="0" err="1">
                  <a:latin typeface="Times" pitchFamily="2" charset="0"/>
                </a:rPr>
                <a:t>Occurence</a:t>
              </a:r>
              <a:endParaRPr lang="ja-JP" altLang="en-US" sz="800">
                <a:latin typeface="Times" pitchFamily="2" charset="0"/>
              </a:endParaRPr>
            </a:p>
          </p:txBody>
        </p:sp>
        <p:cxnSp>
          <p:nvCxnSpPr>
            <p:cNvPr id="222" name="直線コネクタ 221">
              <a:extLst>
                <a:ext uri="{FF2B5EF4-FFF2-40B4-BE49-F238E27FC236}">
                  <a16:creationId xmlns:a16="http://schemas.microsoft.com/office/drawing/2014/main" id="{9203F39D-207A-944F-8DD2-BCDC58B26BFD}"/>
                </a:ext>
              </a:extLst>
            </p:cNvPr>
            <p:cNvCxnSpPr>
              <a:cxnSpLocks/>
            </p:cNvCxnSpPr>
            <p:nvPr/>
          </p:nvCxnSpPr>
          <p:spPr>
            <a:xfrm>
              <a:off x="6817105" y="2997230"/>
              <a:ext cx="28188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3" name="正方形/長方形 222">
              <a:extLst>
                <a:ext uri="{FF2B5EF4-FFF2-40B4-BE49-F238E27FC236}">
                  <a16:creationId xmlns:a16="http://schemas.microsoft.com/office/drawing/2014/main" id="{F8996D1F-732D-0549-87D7-AA358FD65CAC}"/>
                </a:ext>
              </a:extLst>
            </p:cNvPr>
            <p:cNvSpPr/>
            <p:nvPr/>
          </p:nvSpPr>
          <p:spPr>
            <a:xfrm>
              <a:off x="8207921" y="3697176"/>
              <a:ext cx="80079" cy="1074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" pitchFamily="2" charset="0"/>
              </a:endParaRPr>
            </a:p>
          </p:txBody>
        </p:sp>
        <p:sp>
          <p:nvSpPr>
            <p:cNvPr id="224" name="正方形/長方形 223">
              <a:extLst>
                <a:ext uri="{FF2B5EF4-FFF2-40B4-BE49-F238E27FC236}">
                  <a16:creationId xmlns:a16="http://schemas.microsoft.com/office/drawing/2014/main" id="{F1409D55-8EE6-EF41-B25B-32B1C2CE227D}"/>
                </a:ext>
              </a:extLst>
            </p:cNvPr>
            <p:cNvSpPr/>
            <p:nvPr/>
          </p:nvSpPr>
          <p:spPr>
            <a:xfrm>
              <a:off x="6623944" y="3697175"/>
              <a:ext cx="80079" cy="1074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" pitchFamily="2" charset="0"/>
              </a:endParaRPr>
            </a:p>
          </p:txBody>
        </p:sp>
        <p:sp>
          <p:nvSpPr>
            <p:cNvPr id="225" name="テキスト ボックス 224">
              <a:extLst>
                <a:ext uri="{FF2B5EF4-FFF2-40B4-BE49-F238E27FC236}">
                  <a16:creationId xmlns:a16="http://schemas.microsoft.com/office/drawing/2014/main" id="{D5E9DBED-2B2A-D34A-92D9-10001BCD3B2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6290633" y="3600524"/>
              <a:ext cx="758274" cy="1566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800" dirty="0">
                  <a:latin typeface="Times" pitchFamily="2" charset="0"/>
                  <a:ea typeface="HG丸ｺﾞｼｯｸM-PRO" charset="-128"/>
                </a:rPr>
                <a:t>trough ng/ml</a:t>
              </a:r>
            </a:p>
          </p:txBody>
        </p:sp>
        <p:sp>
          <p:nvSpPr>
            <p:cNvPr id="226" name="テキスト ボックス 225">
              <a:extLst>
                <a:ext uri="{FF2B5EF4-FFF2-40B4-BE49-F238E27FC236}">
                  <a16:creationId xmlns:a16="http://schemas.microsoft.com/office/drawing/2014/main" id="{6C4B2D6B-268B-8F40-8BF7-DE0C503D56E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7878099" y="3600523"/>
              <a:ext cx="758276" cy="1566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800" dirty="0">
                  <a:latin typeface="Times" pitchFamily="2" charset="0"/>
                  <a:ea typeface="HG丸ｺﾞｼｯｸM-PRO" charset="-128"/>
                </a:rPr>
                <a:t>trough ng/ml</a:t>
              </a:r>
            </a:p>
          </p:txBody>
        </p:sp>
        <p:sp>
          <p:nvSpPr>
            <p:cNvPr id="227" name="正方形/長方形 226">
              <a:extLst>
                <a:ext uri="{FF2B5EF4-FFF2-40B4-BE49-F238E27FC236}">
                  <a16:creationId xmlns:a16="http://schemas.microsoft.com/office/drawing/2014/main" id="{553FC65E-984E-D44A-81DD-53AD8D83E402}"/>
                </a:ext>
              </a:extLst>
            </p:cNvPr>
            <p:cNvSpPr/>
            <p:nvPr/>
          </p:nvSpPr>
          <p:spPr>
            <a:xfrm>
              <a:off x="8327398" y="4352324"/>
              <a:ext cx="137002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" altLang="ja-JP" sz="800" dirty="0">
                  <a:latin typeface="Times" pitchFamily="2" charset="0"/>
                </a:rPr>
                <a:t>Non-occurrence   </a:t>
              </a:r>
              <a:r>
                <a:rPr lang="en" altLang="ja-JP" sz="800" dirty="0" err="1">
                  <a:latin typeface="Times" pitchFamily="2" charset="0"/>
                </a:rPr>
                <a:t>Occurence</a:t>
              </a:r>
              <a:endParaRPr lang="ja-JP" altLang="en-US" sz="800">
                <a:latin typeface="Times" pitchFamily="2" charset="0"/>
              </a:endParaRPr>
            </a:p>
          </p:txBody>
        </p:sp>
      </p:grp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5DF1F259-D472-CC48-B7FE-F6F36E0C65FE}"/>
              </a:ext>
            </a:extLst>
          </p:cNvPr>
          <p:cNvGrpSpPr/>
          <p:nvPr/>
        </p:nvGrpSpPr>
        <p:grpSpPr>
          <a:xfrm>
            <a:off x="6591455" y="635706"/>
            <a:ext cx="3221808" cy="1928752"/>
            <a:chOff x="6591455" y="635706"/>
            <a:chExt cx="3221808" cy="1928752"/>
          </a:xfrm>
        </p:grpSpPr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E318A797-C63B-E944-B0F9-6096002FD358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6645336" y="818041"/>
              <a:ext cx="1609915" cy="1609915"/>
            </a:xfrm>
            <a:prstGeom prst="rect">
              <a:avLst/>
            </a:prstGeom>
          </p:spPr>
        </p:pic>
        <p:pic>
          <p:nvPicPr>
            <p:cNvPr id="45" name="図 44">
              <a:extLst>
                <a:ext uri="{FF2B5EF4-FFF2-40B4-BE49-F238E27FC236}">
                  <a16:creationId xmlns:a16="http://schemas.microsoft.com/office/drawing/2014/main" id="{18BA8EF8-5FED-A747-BE5F-63649375105C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8205530" y="809610"/>
              <a:ext cx="1607733" cy="1607733"/>
            </a:xfrm>
            <a:prstGeom prst="rect">
              <a:avLst/>
            </a:prstGeom>
          </p:spPr>
        </p:pic>
        <p:sp>
          <p:nvSpPr>
            <p:cNvPr id="170" name="テキスト ボックス 169">
              <a:extLst>
                <a:ext uri="{FF2B5EF4-FFF2-40B4-BE49-F238E27FC236}">
                  <a16:creationId xmlns:a16="http://schemas.microsoft.com/office/drawing/2014/main" id="{C9176F60-7A9E-094D-B4CE-F919F2A1CFA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279132" y="2397817"/>
              <a:ext cx="507111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>
                  <a:latin typeface="Times" pitchFamily="2" charset="0"/>
                  <a:ea typeface="HG丸ｺﾞｼｯｸM-PRO" charset="-128"/>
                </a:rPr>
                <a:t>P=0.32</a:t>
              </a:r>
            </a:p>
          </p:txBody>
        </p:sp>
        <p:sp>
          <p:nvSpPr>
            <p:cNvPr id="171" name="テキスト ボックス 170">
              <a:extLst>
                <a:ext uri="{FF2B5EF4-FFF2-40B4-BE49-F238E27FC236}">
                  <a16:creationId xmlns:a16="http://schemas.microsoft.com/office/drawing/2014/main" id="{18944C0F-26CC-0D4C-A7F8-4F887E94485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842588" y="2407829"/>
              <a:ext cx="580433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>
                  <a:latin typeface="Times" pitchFamily="2" charset="0"/>
                  <a:ea typeface="HG丸ｺﾞｼｯｸM-PRO" charset="-128"/>
                </a:rPr>
                <a:t>P=0.64</a:t>
              </a:r>
            </a:p>
          </p:txBody>
        </p:sp>
        <p:sp>
          <p:nvSpPr>
            <p:cNvPr id="173" name="テキスト ボックス 172">
              <a:extLst>
                <a:ext uri="{FF2B5EF4-FFF2-40B4-BE49-F238E27FC236}">
                  <a16:creationId xmlns:a16="http://schemas.microsoft.com/office/drawing/2014/main" id="{DA26D1F1-B3D1-4E4C-BD42-D8C486A6985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609193" y="635706"/>
              <a:ext cx="1262787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/>
              <a:r>
                <a:rPr lang="en-US" altLang="ja-JP" sz="1400" dirty="0">
                  <a:latin typeface="Times" pitchFamily="2" charset="0"/>
                  <a:ea typeface="HG丸ｺﾞｼｯｸM-PRO" charset="-128"/>
                </a:rPr>
                <a:t>Leukocytopenia</a:t>
              </a:r>
            </a:p>
          </p:txBody>
        </p:sp>
        <p:sp>
          <p:nvSpPr>
            <p:cNvPr id="174" name="テキスト ボックス 173">
              <a:extLst>
                <a:ext uri="{FF2B5EF4-FFF2-40B4-BE49-F238E27FC236}">
                  <a16:creationId xmlns:a16="http://schemas.microsoft.com/office/drawing/2014/main" id="{1E3BAB81-4C44-834C-9A28-12C15AF20BD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188140" y="841342"/>
              <a:ext cx="756133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 err="1">
                  <a:latin typeface="Times" pitchFamily="2" charset="0"/>
                  <a:ea typeface="HG丸ｺﾞｼｯｸM-PRO" charset="-128"/>
                </a:rPr>
                <a:t>Osimertinib</a:t>
              </a:r>
              <a:endParaRPr lang="en-US" altLang="ja-JP" sz="1000" dirty="0">
                <a:latin typeface="Times" pitchFamily="2" charset="0"/>
                <a:ea typeface="HG丸ｺﾞｼｯｸM-PRO" charset="-128"/>
              </a:endParaRPr>
            </a:p>
          </p:txBody>
        </p:sp>
        <p:sp>
          <p:nvSpPr>
            <p:cNvPr id="175" name="テキスト ボックス 174">
              <a:extLst>
                <a:ext uri="{FF2B5EF4-FFF2-40B4-BE49-F238E27FC236}">
                  <a16:creationId xmlns:a16="http://schemas.microsoft.com/office/drawing/2014/main" id="{7D6DB494-F7AB-3D4B-8861-8C4EB23A68B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873433" y="837203"/>
              <a:ext cx="498569" cy="12786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>
                  <a:latin typeface="Times" pitchFamily="2" charset="0"/>
                  <a:ea typeface="HG丸ｺﾞｼｯｸM-PRO" charset="-128"/>
                </a:rPr>
                <a:t>AZ5104</a:t>
              </a:r>
            </a:p>
          </p:txBody>
        </p:sp>
        <p:sp>
          <p:nvSpPr>
            <p:cNvPr id="176" name="正方形/長方形 175">
              <a:extLst>
                <a:ext uri="{FF2B5EF4-FFF2-40B4-BE49-F238E27FC236}">
                  <a16:creationId xmlns:a16="http://schemas.microsoft.com/office/drawing/2014/main" id="{4E054891-66AE-5746-B227-7ACAC6CE45FA}"/>
                </a:ext>
              </a:extLst>
            </p:cNvPr>
            <p:cNvSpPr/>
            <p:nvPr/>
          </p:nvSpPr>
          <p:spPr>
            <a:xfrm>
              <a:off x="6770166" y="2195679"/>
              <a:ext cx="137002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" altLang="ja-JP" sz="800" dirty="0">
                  <a:latin typeface="Times" pitchFamily="2" charset="0"/>
                </a:rPr>
                <a:t>Non-occurrence   </a:t>
              </a:r>
              <a:r>
                <a:rPr lang="en" altLang="ja-JP" sz="800" dirty="0" err="1">
                  <a:latin typeface="Times" pitchFamily="2" charset="0"/>
                </a:rPr>
                <a:t>Occurence</a:t>
              </a:r>
              <a:endParaRPr lang="ja-JP" altLang="en-US" sz="800">
                <a:latin typeface="Times" pitchFamily="2" charset="0"/>
              </a:endParaRPr>
            </a:p>
          </p:txBody>
        </p:sp>
        <p:cxnSp>
          <p:nvCxnSpPr>
            <p:cNvPr id="177" name="直線コネクタ 176">
              <a:extLst>
                <a:ext uri="{FF2B5EF4-FFF2-40B4-BE49-F238E27FC236}">
                  <a16:creationId xmlns:a16="http://schemas.microsoft.com/office/drawing/2014/main" id="{E59AB901-A1D6-5B41-B815-50779D772A95}"/>
                </a:ext>
              </a:extLst>
            </p:cNvPr>
            <p:cNvCxnSpPr>
              <a:cxnSpLocks/>
            </p:cNvCxnSpPr>
            <p:nvPr/>
          </p:nvCxnSpPr>
          <p:spPr>
            <a:xfrm>
              <a:off x="6817105" y="837291"/>
              <a:ext cx="28188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8" name="正方形/長方形 177">
              <a:extLst>
                <a:ext uri="{FF2B5EF4-FFF2-40B4-BE49-F238E27FC236}">
                  <a16:creationId xmlns:a16="http://schemas.microsoft.com/office/drawing/2014/main" id="{9371A660-3B68-4446-B91C-8E277CE2E4C0}"/>
                </a:ext>
              </a:extLst>
            </p:cNvPr>
            <p:cNvSpPr/>
            <p:nvPr/>
          </p:nvSpPr>
          <p:spPr>
            <a:xfrm>
              <a:off x="8207921" y="1537237"/>
              <a:ext cx="80079" cy="1074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" pitchFamily="2" charset="0"/>
              </a:endParaRPr>
            </a:p>
          </p:txBody>
        </p:sp>
        <p:sp>
          <p:nvSpPr>
            <p:cNvPr id="179" name="正方形/長方形 178">
              <a:extLst>
                <a:ext uri="{FF2B5EF4-FFF2-40B4-BE49-F238E27FC236}">
                  <a16:creationId xmlns:a16="http://schemas.microsoft.com/office/drawing/2014/main" id="{84909D37-0620-6F4A-BA6D-20963818CA0E}"/>
                </a:ext>
              </a:extLst>
            </p:cNvPr>
            <p:cNvSpPr/>
            <p:nvPr/>
          </p:nvSpPr>
          <p:spPr>
            <a:xfrm>
              <a:off x="6623944" y="1537236"/>
              <a:ext cx="80079" cy="1074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" pitchFamily="2" charset="0"/>
              </a:endParaRPr>
            </a:p>
          </p:txBody>
        </p:sp>
        <p:sp>
          <p:nvSpPr>
            <p:cNvPr id="180" name="テキスト ボックス 179">
              <a:extLst>
                <a:ext uri="{FF2B5EF4-FFF2-40B4-BE49-F238E27FC236}">
                  <a16:creationId xmlns:a16="http://schemas.microsoft.com/office/drawing/2014/main" id="{324E8D96-32A3-904C-8E5B-EF7C7224F0C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6290633" y="1440585"/>
              <a:ext cx="758274" cy="1566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800" dirty="0">
                  <a:latin typeface="Times" pitchFamily="2" charset="0"/>
                  <a:ea typeface="HG丸ｺﾞｼｯｸM-PRO" charset="-128"/>
                </a:rPr>
                <a:t>trough ng/ml</a:t>
              </a:r>
            </a:p>
          </p:txBody>
        </p:sp>
        <p:sp>
          <p:nvSpPr>
            <p:cNvPr id="181" name="テキスト ボックス 180">
              <a:extLst>
                <a:ext uri="{FF2B5EF4-FFF2-40B4-BE49-F238E27FC236}">
                  <a16:creationId xmlns:a16="http://schemas.microsoft.com/office/drawing/2014/main" id="{1FCA00A7-F102-AB43-A5D9-9C1821C8B7C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7878099" y="1440584"/>
              <a:ext cx="758276" cy="1566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800" dirty="0">
                  <a:latin typeface="Times" pitchFamily="2" charset="0"/>
                  <a:ea typeface="HG丸ｺﾞｼｯｸM-PRO" charset="-128"/>
                </a:rPr>
                <a:t>trough ng/ml</a:t>
              </a:r>
            </a:p>
          </p:txBody>
        </p:sp>
        <p:sp>
          <p:nvSpPr>
            <p:cNvPr id="182" name="正方形/長方形 181">
              <a:extLst>
                <a:ext uri="{FF2B5EF4-FFF2-40B4-BE49-F238E27FC236}">
                  <a16:creationId xmlns:a16="http://schemas.microsoft.com/office/drawing/2014/main" id="{8D043137-FAB7-7240-A976-E71DFCF90FE3}"/>
                </a:ext>
              </a:extLst>
            </p:cNvPr>
            <p:cNvSpPr/>
            <p:nvPr/>
          </p:nvSpPr>
          <p:spPr>
            <a:xfrm>
              <a:off x="8327398" y="2192385"/>
              <a:ext cx="137002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" altLang="ja-JP" sz="800" dirty="0">
                  <a:latin typeface="Times" pitchFamily="2" charset="0"/>
                </a:rPr>
                <a:t>Non-occurrence   </a:t>
              </a:r>
              <a:r>
                <a:rPr lang="en" altLang="ja-JP" sz="800" dirty="0" err="1">
                  <a:latin typeface="Times" pitchFamily="2" charset="0"/>
                </a:rPr>
                <a:t>Occurence</a:t>
              </a:r>
              <a:endParaRPr lang="ja-JP" altLang="en-US" sz="800">
                <a:latin typeface="Times" pitchFamily="2" charset="0"/>
              </a:endParaRPr>
            </a:p>
          </p:txBody>
        </p:sp>
      </p:grpSp>
      <p:pic>
        <p:nvPicPr>
          <p:cNvPr id="14" name="図 13">
            <a:extLst>
              <a:ext uri="{FF2B5EF4-FFF2-40B4-BE49-F238E27FC236}">
                <a16:creationId xmlns:a16="http://schemas.microsoft.com/office/drawing/2014/main" id="{B4BAF8FE-69AC-9A4C-8B45-8CB4E935D0FE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404772" y="2896649"/>
            <a:ext cx="1616055" cy="1616055"/>
          </a:xfrm>
          <a:prstGeom prst="rect">
            <a:avLst/>
          </a:prstGeom>
        </p:spPr>
      </p:pic>
      <p:pic>
        <p:nvPicPr>
          <p:cNvPr id="39" name="図 38">
            <a:extLst>
              <a:ext uri="{FF2B5EF4-FFF2-40B4-BE49-F238E27FC236}">
                <a16:creationId xmlns:a16="http://schemas.microsoft.com/office/drawing/2014/main" id="{3E6ABD98-AE46-844A-A70A-5575A5058D9A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973155" y="2890014"/>
            <a:ext cx="1613025" cy="1613025"/>
          </a:xfrm>
          <a:prstGeom prst="rect">
            <a:avLst/>
          </a:prstGeom>
        </p:spPr>
      </p:pic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7DD2B1A6-6824-994A-A05B-64B289DE67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46473" y="4484793"/>
            <a:ext cx="507111" cy="156629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no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r>
              <a:rPr lang="en-US" altLang="ja-JP" sz="1000" dirty="0">
                <a:latin typeface="Times" pitchFamily="2" charset="0"/>
                <a:ea typeface="HG丸ｺﾞｼｯｸM-PRO" charset="-128"/>
              </a:rPr>
              <a:t>P=0.74</a:t>
            </a:r>
          </a:p>
        </p:txBody>
      </p: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id="{EBC87D0D-C859-8A4C-BA96-12C3768641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09929" y="4494805"/>
            <a:ext cx="580433" cy="156629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no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r>
              <a:rPr lang="en-US" altLang="ja-JP" sz="1000" dirty="0">
                <a:latin typeface="Times" pitchFamily="2" charset="0"/>
                <a:ea typeface="HG丸ｺﾞｼｯｸM-PRO" charset="-128"/>
              </a:rPr>
              <a:t>P=0.92</a:t>
            </a:r>
          </a:p>
        </p:txBody>
      </p: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id="{60D9D60D-2A84-984A-BF6A-34C1877A46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76534" y="2722682"/>
            <a:ext cx="1262787" cy="156629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no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/>
            <a:r>
              <a:rPr lang="en-US" altLang="ja-JP" sz="1400" dirty="0">
                <a:latin typeface="Times" pitchFamily="2" charset="0"/>
                <a:ea typeface="HG丸ｺﾞｼｯｸM-PRO" charset="-128"/>
              </a:rPr>
              <a:t>Vomiting</a:t>
            </a:r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25C960E4-F760-0146-AF5C-9957F246575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55481" y="2928318"/>
            <a:ext cx="756133" cy="156629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no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r>
              <a:rPr lang="en-US" altLang="ja-JP" sz="1000" dirty="0" err="1">
                <a:latin typeface="Times" pitchFamily="2" charset="0"/>
                <a:ea typeface="HG丸ｺﾞｼｯｸM-PRO" charset="-128"/>
              </a:rPr>
              <a:t>Osimertinib</a:t>
            </a:r>
            <a:endParaRPr lang="en-US" altLang="ja-JP" sz="1000" dirty="0">
              <a:latin typeface="Times" pitchFamily="2" charset="0"/>
              <a:ea typeface="HG丸ｺﾞｼｯｸM-PRO" charset="-128"/>
            </a:endParaRPr>
          </a:p>
        </p:txBody>
      </p:sp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id="{EE2CF945-DC43-EC4A-9A6C-9F6081C336A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40774" y="2924179"/>
            <a:ext cx="498569" cy="115971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no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r>
              <a:rPr lang="en-US" altLang="ja-JP" sz="1000" dirty="0">
                <a:latin typeface="Times" pitchFamily="2" charset="0"/>
                <a:ea typeface="HG丸ｺﾞｼｯｸM-PRO" charset="-128"/>
              </a:rPr>
              <a:t>AZ5104</a:t>
            </a:r>
          </a:p>
        </p:txBody>
      </p:sp>
      <p:sp>
        <p:nvSpPr>
          <p:cNvPr id="161" name="正方形/長方形 160">
            <a:extLst>
              <a:ext uri="{FF2B5EF4-FFF2-40B4-BE49-F238E27FC236}">
                <a16:creationId xmlns:a16="http://schemas.microsoft.com/office/drawing/2014/main" id="{3E14711A-8F60-C747-8CFE-EB384DB7C400}"/>
              </a:ext>
            </a:extLst>
          </p:cNvPr>
          <p:cNvSpPr/>
          <p:nvPr/>
        </p:nvSpPr>
        <p:spPr>
          <a:xfrm>
            <a:off x="3537507" y="4282655"/>
            <a:ext cx="1370027" cy="215444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" altLang="ja-JP" sz="800" dirty="0">
                <a:latin typeface="Times" pitchFamily="2" charset="0"/>
              </a:rPr>
              <a:t>Non-occurrence   </a:t>
            </a:r>
            <a:r>
              <a:rPr lang="en" altLang="ja-JP" sz="800" dirty="0" err="1">
                <a:latin typeface="Times" pitchFamily="2" charset="0"/>
              </a:rPr>
              <a:t>Occurence</a:t>
            </a:r>
            <a:endParaRPr lang="ja-JP" altLang="en-US" sz="800">
              <a:latin typeface="Times" pitchFamily="2" charset="0"/>
            </a:endParaRPr>
          </a:p>
        </p:txBody>
      </p:sp>
      <p:cxnSp>
        <p:nvCxnSpPr>
          <p:cNvPr id="162" name="直線コネクタ 161">
            <a:extLst>
              <a:ext uri="{FF2B5EF4-FFF2-40B4-BE49-F238E27FC236}">
                <a16:creationId xmlns:a16="http://schemas.microsoft.com/office/drawing/2014/main" id="{4445FE26-9429-0C47-BC32-9F0EF6040B06}"/>
              </a:ext>
            </a:extLst>
          </p:cNvPr>
          <p:cNvCxnSpPr>
            <a:cxnSpLocks/>
          </p:cNvCxnSpPr>
          <p:nvPr/>
        </p:nvCxnSpPr>
        <p:spPr>
          <a:xfrm>
            <a:off x="3584446" y="2924267"/>
            <a:ext cx="281884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正方形/長方形 162">
            <a:extLst>
              <a:ext uri="{FF2B5EF4-FFF2-40B4-BE49-F238E27FC236}">
                <a16:creationId xmlns:a16="http://schemas.microsoft.com/office/drawing/2014/main" id="{54DA29B1-1538-A34C-9B04-E7638B045A6E}"/>
              </a:ext>
            </a:extLst>
          </p:cNvPr>
          <p:cNvSpPr/>
          <p:nvPr/>
        </p:nvSpPr>
        <p:spPr>
          <a:xfrm>
            <a:off x="4975262" y="3624213"/>
            <a:ext cx="80079" cy="10748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64" name="正方形/長方形 163">
            <a:extLst>
              <a:ext uri="{FF2B5EF4-FFF2-40B4-BE49-F238E27FC236}">
                <a16:creationId xmlns:a16="http://schemas.microsoft.com/office/drawing/2014/main" id="{3F50D88B-74AC-364C-876D-84173C43382A}"/>
              </a:ext>
            </a:extLst>
          </p:cNvPr>
          <p:cNvSpPr/>
          <p:nvPr/>
        </p:nvSpPr>
        <p:spPr>
          <a:xfrm>
            <a:off x="3391285" y="3624212"/>
            <a:ext cx="80079" cy="10748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65" name="テキスト ボックス 164">
            <a:extLst>
              <a:ext uri="{FF2B5EF4-FFF2-40B4-BE49-F238E27FC236}">
                <a16:creationId xmlns:a16="http://schemas.microsoft.com/office/drawing/2014/main" id="{23880A3D-6C5F-0445-B4B4-8CC9B1914F2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057974" y="3527561"/>
            <a:ext cx="758274" cy="1566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no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r>
              <a:rPr lang="en-US" altLang="ja-JP" sz="800" dirty="0">
                <a:latin typeface="Times" pitchFamily="2" charset="0"/>
                <a:ea typeface="HG丸ｺﾞｼｯｸM-PRO" charset="-128"/>
              </a:rPr>
              <a:t>trough ng/ml</a:t>
            </a:r>
          </a:p>
        </p:txBody>
      </p:sp>
      <p:sp>
        <p:nvSpPr>
          <p:cNvPr id="166" name="テキスト ボックス 165">
            <a:extLst>
              <a:ext uri="{FF2B5EF4-FFF2-40B4-BE49-F238E27FC236}">
                <a16:creationId xmlns:a16="http://schemas.microsoft.com/office/drawing/2014/main" id="{BCE8D7AC-1959-BD40-A491-76F59C5987AD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645440" y="3527560"/>
            <a:ext cx="758276" cy="1566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no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r>
              <a:rPr lang="en-US" altLang="ja-JP" sz="800" dirty="0">
                <a:latin typeface="Times" pitchFamily="2" charset="0"/>
                <a:ea typeface="HG丸ｺﾞｼｯｸM-PRO" charset="-128"/>
              </a:rPr>
              <a:t>trough ng/ml</a:t>
            </a:r>
          </a:p>
        </p:txBody>
      </p:sp>
      <p:sp>
        <p:nvSpPr>
          <p:cNvPr id="167" name="正方形/長方形 166">
            <a:extLst>
              <a:ext uri="{FF2B5EF4-FFF2-40B4-BE49-F238E27FC236}">
                <a16:creationId xmlns:a16="http://schemas.microsoft.com/office/drawing/2014/main" id="{3182FF56-CF5A-CB4A-B369-A1A571EDE7C5}"/>
              </a:ext>
            </a:extLst>
          </p:cNvPr>
          <p:cNvSpPr/>
          <p:nvPr/>
        </p:nvSpPr>
        <p:spPr>
          <a:xfrm>
            <a:off x="5094739" y="4279361"/>
            <a:ext cx="1370027" cy="215444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" altLang="ja-JP" sz="800" dirty="0">
                <a:latin typeface="Times" pitchFamily="2" charset="0"/>
              </a:rPr>
              <a:t>Non-occurrence   </a:t>
            </a:r>
            <a:r>
              <a:rPr lang="en" altLang="ja-JP" sz="800" dirty="0" err="1">
                <a:latin typeface="Times" pitchFamily="2" charset="0"/>
              </a:rPr>
              <a:t>Occurence</a:t>
            </a:r>
            <a:endParaRPr lang="ja-JP" altLang="en-US" sz="800">
              <a:latin typeface="Times" pitchFamily="2" charset="0"/>
            </a:endParaRPr>
          </a:p>
        </p:txBody>
      </p: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69EC3ABB-1B40-9E4C-A562-0979D7DE7E1B}"/>
              </a:ext>
            </a:extLst>
          </p:cNvPr>
          <p:cNvGrpSpPr/>
          <p:nvPr/>
        </p:nvGrpSpPr>
        <p:grpSpPr>
          <a:xfrm>
            <a:off x="3342544" y="4829844"/>
            <a:ext cx="3231880" cy="1928752"/>
            <a:chOff x="154677" y="2722682"/>
            <a:chExt cx="3231880" cy="1928752"/>
          </a:xfrm>
        </p:grpSpPr>
        <p:pic>
          <p:nvPicPr>
            <p:cNvPr id="12" name="図 11">
              <a:extLst>
                <a:ext uri="{FF2B5EF4-FFF2-40B4-BE49-F238E27FC236}">
                  <a16:creationId xmlns:a16="http://schemas.microsoft.com/office/drawing/2014/main" id="{1AC69F99-6F6D-4B4E-9094-F0FB8B8596F2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206523" y="2899063"/>
              <a:ext cx="1613641" cy="1613641"/>
            </a:xfrm>
            <a:prstGeom prst="rect">
              <a:avLst/>
            </a:prstGeom>
          </p:spPr>
        </p:pic>
        <p:pic>
          <p:nvPicPr>
            <p:cNvPr id="33" name="図 32">
              <a:extLst>
                <a:ext uri="{FF2B5EF4-FFF2-40B4-BE49-F238E27FC236}">
                  <a16:creationId xmlns:a16="http://schemas.microsoft.com/office/drawing/2014/main" id="{79C439AB-2801-CE40-AFDD-9AAE97DFB91B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1770749" y="2895060"/>
              <a:ext cx="1615808" cy="1615808"/>
            </a:xfrm>
            <a:prstGeom prst="rect">
              <a:avLst/>
            </a:prstGeom>
          </p:spPr>
        </p:pic>
        <p:sp>
          <p:nvSpPr>
            <p:cNvPr id="140" name="テキスト ボックス 139">
              <a:extLst>
                <a:ext uri="{FF2B5EF4-FFF2-40B4-BE49-F238E27FC236}">
                  <a16:creationId xmlns:a16="http://schemas.microsoft.com/office/drawing/2014/main" id="{31A3E8C7-25CF-E546-852D-D83679ED52D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42354" y="4484793"/>
              <a:ext cx="507111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>
                  <a:latin typeface="Times" pitchFamily="2" charset="0"/>
                  <a:ea typeface="HG丸ｺﾞｼｯｸM-PRO" charset="-128"/>
                </a:rPr>
                <a:t>P=0.27</a:t>
              </a:r>
            </a:p>
          </p:txBody>
        </p:sp>
        <p:sp>
          <p:nvSpPr>
            <p:cNvPr id="141" name="テキスト ボックス 140">
              <a:extLst>
                <a:ext uri="{FF2B5EF4-FFF2-40B4-BE49-F238E27FC236}">
                  <a16:creationId xmlns:a16="http://schemas.microsoft.com/office/drawing/2014/main" id="{5DAEC8AC-4DBF-204C-AC9B-3E91312D867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05810" y="4494805"/>
              <a:ext cx="580433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>
                  <a:latin typeface="Times" pitchFamily="2" charset="0"/>
                  <a:ea typeface="HG丸ｺﾞｼｯｸM-PRO" charset="-128"/>
                </a:rPr>
                <a:t>P=0.24</a:t>
              </a:r>
            </a:p>
          </p:txBody>
        </p:sp>
        <p:sp>
          <p:nvSpPr>
            <p:cNvPr id="143" name="テキスト ボックス 142">
              <a:extLst>
                <a:ext uri="{FF2B5EF4-FFF2-40B4-BE49-F238E27FC236}">
                  <a16:creationId xmlns:a16="http://schemas.microsoft.com/office/drawing/2014/main" id="{99140621-7256-0441-B513-DD45E874FD1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72415" y="2722682"/>
              <a:ext cx="1262787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/>
              <a:r>
                <a:rPr lang="en-US" altLang="ja-JP" sz="1400" dirty="0">
                  <a:latin typeface="Times" pitchFamily="2" charset="0"/>
                  <a:ea typeface="HG丸ｺﾞｼｯｸM-PRO" charset="-128"/>
                </a:rPr>
                <a:t>QT prolongation</a:t>
              </a:r>
            </a:p>
          </p:txBody>
        </p:sp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id="{607F7FC2-9E9A-F34F-B536-35DF04260D3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51362" y="2928318"/>
              <a:ext cx="756133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 err="1">
                  <a:latin typeface="Times" pitchFamily="2" charset="0"/>
                  <a:ea typeface="HG丸ｺﾞｼｯｸM-PRO" charset="-128"/>
                </a:rPr>
                <a:t>Osimertinib</a:t>
              </a:r>
              <a:endParaRPr lang="en-US" altLang="ja-JP" sz="1000" dirty="0">
                <a:latin typeface="Times" pitchFamily="2" charset="0"/>
                <a:ea typeface="HG丸ｺﾞｼｯｸM-PRO" charset="-128"/>
              </a:endParaRPr>
            </a:p>
          </p:txBody>
        </p:sp>
        <p:sp>
          <p:nvSpPr>
            <p:cNvPr id="145" name="テキスト ボックス 144">
              <a:extLst>
                <a:ext uri="{FF2B5EF4-FFF2-40B4-BE49-F238E27FC236}">
                  <a16:creationId xmlns:a16="http://schemas.microsoft.com/office/drawing/2014/main" id="{A30CEABB-1EFF-364E-AE5E-5D0B200BF32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36655" y="2924179"/>
              <a:ext cx="498569" cy="11597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>
                  <a:latin typeface="Times" pitchFamily="2" charset="0"/>
                  <a:ea typeface="HG丸ｺﾞｼｯｸM-PRO" charset="-128"/>
                </a:rPr>
                <a:t>AZ5104</a:t>
              </a:r>
            </a:p>
          </p:txBody>
        </p:sp>
        <p:sp>
          <p:nvSpPr>
            <p:cNvPr id="146" name="正方形/長方形 145">
              <a:extLst>
                <a:ext uri="{FF2B5EF4-FFF2-40B4-BE49-F238E27FC236}">
                  <a16:creationId xmlns:a16="http://schemas.microsoft.com/office/drawing/2014/main" id="{D7AFF4D9-826C-E847-8659-3C90747688C0}"/>
                </a:ext>
              </a:extLst>
            </p:cNvPr>
            <p:cNvSpPr/>
            <p:nvPr/>
          </p:nvSpPr>
          <p:spPr>
            <a:xfrm>
              <a:off x="333388" y="4282655"/>
              <a:ext cx="137002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" altLang="ja-JP" sz="800" dirty="0">
                  <a:latin typeface="Times" pitchFamily="2" charset="0"/>
                </a:rPr>
                <a:t>Non-occurrence   </a:t>
              </a:r>
              <a:r>
                <a:rPr lang="en" altLang="ja-JP" sz="800" dirty="0" err="1">
                  <a:latin typeface="Times" pitchFamily="2" charset="0"/>
                </a:rPr>
                <a:t>Occurence</a:t>
              </a:r>
              <a:endParaRPr lang="ja-JP" altLang="en-US" sz="800">
                <a:latin typeface="Times" pitchFamily="2" charset="0"/>
              </a:endParaRPr>
            </a:p>
          </p:txBody>
        </p:sp>
        <p:cxnSp>
          <p:nvCxnSpPr>
            <p:cNvPr id="147" name="直線コネクタ 146">
              <a:extLst>
                <a:ext uri="{FF2B5EF4-FFF2-40B4-BE49-F238E27FC236}">
                  <a16:creationId xmlns:a16="http://schemas.microsoft.com/office/drawing/2014/main" id="{F76BEFB3-A31D-6D4F-9ED2-4984ADAF62F8}"/>
                </a:ext>
              </a:extLst>
            </p:cNvPr>
            <p:cNvCxnSpPr>
              <a:cxnSpLocks/>
            </p:cNvCxnSpPr>
            <p:nvPr/>
          </p:nvCxnSpPr>
          <p:spPr>
            <a:xfrm>
              <a:off x="380327" y="2924267"/>
              <a:ext cx="28188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8" name="正方形/長方形 147">
              <a:extLst>
                <a:ext uri="{FF2B5EF4-FFF2-40B4-BE49-F238E27FC236}">
                  <a16:creationId xmlns:a16="http://schemas.microsoft.com/office/drawing/2014/main" id="{6380609B-06AA-D943-BCEE-64CCA329144B}"/>
                </a:ext>
              </a:extLst>
            </p:cNvPr>
            <p:cNvSpPr/>
            <p:nvPr/>
          </p:nvSpPr>
          <p:spPr>
            <a:xfrm>
              <a:off x="1771143" y="3624213"/>
              <a:ext cx="80079" cy="1074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" pitchFamily="2" charset="0"/>
              </a:endParaRPr>
            </a:p>
          </p:txBody>
        </p:sp>
        <p:sp>
          <p:nvSpPr>
            <p:cNvPr id="149" name="正方形/長方形 148">
              <a:extLst>
                <a:ext uri="{FF2B5EF4-FFF2-40B4-BE49-F238E27FC236}">
                  <a16:creationId xmlns:a16="http://schemas.microsoft.com/office/drawing/2014/main" id="{6367DB55-C3EA-394D-A820-A240AD2506A0}"/>
                </a:ext>
              </a:extLst>
            </p:cNvPr>
            <p:cNvSpPr/>
            <p:nvPr/>
          </p:nvSpPr>
          <p:spPr>
            <a:xfrm>
              <a:off x="187166" y="3624212"/>
              <a:ext cx="80079" cy="1074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" pitchFamily="2" charset="0"/>
              </a:endParaRPr>
            </a:p>
          </p:txBody>
        </p: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296ED7AD-F079-3944-AEEF-1F741B79DFA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-146145" y="3527561"/>
              <a:ext cx="758274" cy="1566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800" dirty="0">
                  <a:latin typeface="Times" pitchFamily="2" charset="0"/>
                  <a:ea typeface="HG丸ｺﾞｼｯｸM-PRO" charset="-128"/>
                </a:rPr>
                <a:t>trough ng/ml</a:t>
              </a:r>
            </a:p>
          </p:txBody>
        </p:sp>
        <p:sp>
          <p:nvSpPr>
            <p:cNvPr id="151" name="テキスト ボックス 150">
              <a:extLst>
                <a:ext uri="{FF2B5EF4-FFF2-40B4-BE49-F238E27FC236}">
                  <a16:creationId xmlns:a16="http://schemas.microsoft.com/office/drawing/2014/main" id="{AC2CA11A-CBAB-DE46-8DFD-87456F85E16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441321" y="3527560"/>
              <a:ext cx="758276" cy="1566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800" dirty="0">
                  <a:latin typeface="Times" pitchFamily="2" charset="0"/>
                  <a:ea typeface="HG丸ｺﾞｼｯｸM-PRO" charset="-128"/>
                </a:rPr>
                <a:t>trough ng/ml</a:t>
              </a:r>
            </a:p>
          </p:txBody>
        </p:sp>
        <p:sp>
          <p:nvSpPr>
            <p:cNvPr id="152" name="正方形/長方形 151">
              <a:extLst>
                <a:ext uri="{FF2B5EF4-FFF2-40B4-BE49-F238E27FC236}">
                  <a16:creationId xmlns:a16="http://schemas.microsoft.com/office/drawing/2014/main" id="{AD371101-B093-C848-8F34-B83B39B7083E}"/>
                </a:ext>
              </a:extLst>
            </p:cNvPr>
            <p:cNvSpPr/>
            <p:nvPr/>
          </p:nvSpPr>
          <p:spPr>
            <a:xfrm>
              <a:off x="1890620" y="4279361"/>
              <a:ext cx="137002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" altLang="ja-JP" sz="800" dirty="0">
                  <a:latin typeface="Times" pitchFamily="2" charset="0"/>
                </a:rPr>
                <a:t>Non-occurrence   </a:t>
              </a:r>
              <a:r>
                <a:rPr lang="en" altLang="ja-JP" sz="800" dirty="0" err="1">
                  <a:latin typeface="Times" pitchFamily="2" charset="0"/>
                </a:rPr>
                <a:t>Occurence</a:t>
              </a:r>
              <a:endParaRPr lang="ja-JP" altLang="en-US" sz="800">
                <a:latin typeface="Times" pitchFamily="2" charset="0"/>
              </a:endParaRPr>
            </a:p>
          </p:txBody>
        </p:sp>
      </p:grp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03C3FCDB-1046-854B-81B9-B62A6CBD0761}"/>
              </a:ext>
            </a:extLst>
          </p:cNvPr>
          <p:cNvGrpSpPr/>
          <p:nvPr/>
        </p:nvGrpSpPr>
        <p:grpSpPr>
          <a:xfrm>
            <a:off x="3376100" y="643991"/>
            <a:ext cx="3241662" cy="1928752"/>
            <a:chOff x="3376100" y="643991"/>
            <a:chExt cx="3241662" cy="1928752"/>
          </a:xfrm>
        </p:grpSpPr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3B3054DA-E8B7-D34E-8AB5-E5CAA1741E72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3428654" y="821147"/>
              <a:ext cx="1609965" cy="1609965"/>
            </a:xfrm>
            <a:prstGeom prst="rect">
              <a:avLst/>
            </a:prstGeom>
          </p:spPr>
        </p:pic>
        <p:pic>
          <p:nvPicPr>
            <p:cNvPr id="37" name="図 36">
              <a:extLst>
                <a:ext uri="{FF2B5EF4-FFF2-40B4-BE49-F238E27FC236}">
                  <a16:creationId xmlns:a16="http://schemas.microsoft.com/office/drawing/2014/main" id="{06F43695-E1FC-8A42-AA2B-B6C06ECD1AF1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4993056" y="810256"/>
              <a:ext cx="1624706" cy="1624706"/>
            </a:xfrm>
            <a:prstGeom prst="rect">
              <a:avLst/>
            </a:prstGeom>
          </p:spPr>
        </p:pic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5257728C-525A-A74D-825C-5C512AC98FD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63777" y="2406102"/>
              <a:ext cx="507111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>
                  <a:latin typeface="Times" pitchFamily="2" charset="0"/>
                  <a:ea typeface="HG丸ｺﾞｼｯｸM-PRO" charset="-128"/>
                </a:rPr>
                <a:t>P=0.15</a:t>
              </a:r>
            </a:p>
          </p:txBody>
        </p: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B7E5D5C7-FB19-5546-9A8F-88F5EF06EE2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27233" y="2416114"/>
              <a:ext cx="580433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>
                  <a:latin typeface="Times" pitchFamily="2" charset="0"/>
                  <a:ea typeface="HG丸ｺﾞｼｯｸM-PRO" charset="-128"/>
                </a:rPr>
                <a:t>P=0.27</a:t>
              </a:r>
            </a:p>
          </p:txBody>
        </p:sp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C2EFB8A5-CE40-B944-82CB-1241996F5B5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93838" y="643991"/>
              <a:ext cx="1262787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/>
              <a:r>
                <a:rPr lang="en-US" altLang="ja-JP" sz="1400" dirty="0">
                  <a:latin typeface="Times" pitchFamily="2" charset="0"/>
                  <a:ea typeface="HG丸ｺﾞｼｯｸM-PRO" charset="-128"/>
                </a:rPr>
                <a:t>Nausea</a:t>
              </a:r>
            </a:p>
          </p:txBody>
        </p: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148B1A5A-E7EB-5C45-9B06-1F2680AAD99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72785" y="849627"/>
              <a:ext cx="756133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 err="1">
                  <a:latin typeface="Times" pitchFamily="2" charset="0"/>
                  <a:ea typeface="HG丸ｺﾞｼｯｸM-PRO" charset="-128"/>
                </a:rPr>
                <a:t>Osimertinib</a:t>
              </a:r>
              <a:endParaRPr lang="en-US" altLang="ja-JP" sz="1000" dirty="0">
                <a:latin typeface="Times" pitchFamily="2" charset="0"/>
                <a:ea typeface="HG丸ｺﾞｼｯｸM-PRO" charset="-128"/>
              </a:endParaRPr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B157CBC9-9E1E-3D4D-B9A7-B6905C0BFAD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58078" y="845489"/>
              <a:ext cx="498569" cy="1159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>
                  <a:latin typeface="Times" pitchFamily="2" charset="0"/>
                  <a:ea typeface="HG丸ｺﾞｼｯｸM-PRO" charset="-128"/>
                </a:rPr>
                <a:t>AZ5104</a:t>
              </a:r>
            </a:p>
          </p:txBody>
        </p:sp>
        <p:sp>
          <p:nvSpPr>
            <p:cNvPr id="71" name="正方形/長方形 70">
              <a:extLst>
                <a:ext uri="{FF2B5EF4-FFF2-40B4-BE49-F238E27FC236}">
                  <a16:creationId xmlns:a16="http://schemas.microsoft.com/office/drawing/2014/main" id="{EDFF79DB-4AF8-4246-937E-A6EDC11A8FDE}"/>
                </a:ext>
              </a:extLst>
            </p:cNvPr>
            <p:cNvSpPr/>
            <p:nvPr/>
          </p:nvSpPr>
          <p:spPr>
            <a:xfrm>
              <a:off x="3554811" y="2203964"/>
              <a:ext cx="137002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" altLang="ja-JP" sz="800" dirty="0">
                  <a:latin typeface="Times" pitchFamily="2" charset="0"/>
                </a:rPr>
                <a:t>Non-occurrence   </a:t>
              </a:r>
              <a:r>
                <a:rPr lang="en" altLang="ja-JP" sz="800" dirty="0" err="1">
                  <a:latin typeface="Times" pitchFamily="2" charset="0"/>
                </a:rPr>
                <a:t>Occurence</a:t>
              </a:r>
              <a:endParaRPr lang="ja-JP" altLang="en-US" sz="800">
                <a:latin typeface="Times" pitchFamily="2" charset="0"/>
              </a:endParaRPr>
            </a:p>
          </p:txBody>
        </p:sp>
        <p:cxnSp>
          <p:nvCxnSpPr>
            <p:cNvPr id="72" name="直線コネクタ 71">
              <a:extLst>
                <a:ext uri="{FF2B5EF4-FFF2-40B4-BE49-F238E27FC236}">
                  <a16:creationId xmlns:a16="http://schemas.microsoft.com/office/drawing/2014/main" id="{7A877B5A-6DE7-D74D-8207-24F39A98AC37}"/>
                </a:ext>
              </a:extLst>
            </p:cNvPr>
            <p:cNvCxnSpPr>
              <a:cxnSpLocks/>
            </p:cNvCxnSpPr>
            <p:nvPr/>
          </p:nvCxnSpPr>
          <p:spPr>
            <a:xfrm>
              <a:off x="3601750" y="845576"/>
              <a:ext cx="28188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正方形/長方形 72">
              <a:extLst>
                <a:ext uri="{FF2B5EF4-FFF2-40B4-BE49-F238E27FC236}">
                  <a16:creationId xmlns:a16="http://schemas.microsoft.com/office/drawing/2014/main" id="{162FD096-6A2F-0845-92DE-5DF278EA6B6D}"/>
                </a:ext>
              </a:extLst>
            </p:cNvPr>
            <p:cNvSpPr/>
            <p:nvPr/>
          </p:nvSpPr>
          <p:spPr>
            <a:xfrm>
              <a:off x="4992566" y="1545522"/>
              <a:ext cx="80079" cy="1074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" pitchFamily="2" charset="0"/>
              </a:endParaRPr>
            </a:p>
          </p:txBody>
        </p:sp>
        <p:sp>
          <p:nvSpPr>
            <p:cNvPr id="74" name="正方形/長方形 73">
              <a:extLst>
                <a:ext uri="{FF2B5EF4-FFF2-40B4-BE49-F238E27FC236}">
                  <a16:creationId xmlns:a16="http://schemas.microsoft.com/office/drawing/2014/main" id="{CDED2DD7-8466-3540-A230-B0A9638BB532}"/>
                </a:ext>
              </a:extLst>
            </p:cNvPr>
            <p:cNvSpPr/>
            <p:nvPr/>
          </p:nvSpPr>
          <p:spPr>
            <a:xfrm>
              <a:off x="3408589" y="1545521"/>
              <a:ext cx="80079" cy="1074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" pitchFamily="2" charset="0"/>
              </a:endParaRPr>
            </a:p>
          </p:txBody>
        </p:sp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id="{1532423D-B143-7743-BC8C-B6C068D87E3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075278" y="1448870"/>
              <a:ext cx="758274" cy="1566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800" dirty="0">
                  <a:latin typeface="Times" pitchFamily="2" charset="0"/>
                  <a:ea typeface="HG丸ｺﾞｼｯｸM-PRO" charset="-128"/>
                </a:rPr>
                <a:t>trough ng/ml</a:t>
              </a:r>
            </a:p>
          </p:txBody>
        </p:sp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id="{2173B336-6CEB-0E4F-BB97-A14A9902DDE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662744" y="1448869"/>
              <a:ext cx="758276" cy="1566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800" dirty="0">
                  <a:latin typeface="Times" pitchFamily="2" charset="0"/>
                  <a:ea typeface="HG丸ｺﾞｼｯｸM-PRO" charset="-128"/>
                </a:rPr>
                <a:t>trough ng/ml</a:t>
              </a:r>
            </a:p>
          </p:txBody>
        </p:sp>
        <p:sp>
          <p:nvSpPr>
            <p:cNvPr id="77" name="正方形/長方形 76">
              <a:extLst>
                <a:ext uri="{FF2B5EF4-FFF2-40B4-BE49-F238E27FC236}">
                  <a16:creationId xmlns:a16="http://schemas.microsoft.com/office/drawing/2014/main" id="{4988B596-C0BE-D04E-B5A5-907395FDE1E0}"/>
                </a:ext>
              </a:extLst>
            </p:cNvPr>
            <p:cNvSpPr/>
            <p:nvPr/>
          </p:nvSpPr>
          <p:spPr>
            <a:xfrm>
              <a:off x="5112043" y="2200670"/>
              <a:ext cx="137002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" altLang="ja-JP" sz="800" dirty="0">
                  <a:latin typeface="Times" pitchFamily="2" charset="0"/>
                </a:rPr>
                <a:t>Non-occurrence   </a:t>
              </a:r>
              <a:r>
                <a:rPr lang="en" altLang="ja-JP" sz="800" dirty="0" err="1">
                  <a:latin typeface="Times" pitchFamily="2" charset="0"/>
                </a:rPr>
                <a:t>Occurence</a:t>
              </a:r>
              <a:endParaRPr lang="ja-JP" altLang="en-US" sz="800">
                <a:latin typeface="Times" pitchFamily="2" charset="0"/>
              </a:endParaRPr>
            </a:p>
          </p:txBody>
        </p:sp>
      </p:grp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97593BAA-AD2B-9D41-8941-E13ED3C6E594}"/>
              </a:ext>
            </a:extLst>
          </p:cNvPr>
          <p:cNvSpPr txBox="1"/>
          <p:nvPr/>
        </p:nvSpPr>
        <p:spPr>
          <a:xfrm>
            <a:off x="168164" y="91966"/>
            <a:ext cx="254922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Supplementary Figure 3</a:t>
            </a:r>
          </a:p>
          <a:p>
            <a:r>
              <a:rPr lang="en-US" altLang="ja-JP" sz="1400" dirty="0">
                <a:latin typeface="Helvetica" pitchFamily="2" charset="0"/>
              </a:rPr>
              <a:t>Fukuhara et al.</a:t>
            </a:r>
            <a:endParaRPr kumimoji="1" lang="ja-JP" altLang="en-US" sz="1400">
              <a:latin typeface="Helvetica" pitchFamily="2" charset="0"/>
            </a:endParaRPr>
          </a:p>
        </p:txBody>
      </p:sp>
      <p:pic>
        <p:nvPicPr>
          <p:cNvPr id="61" name="図 60">
            <a:extLst>
              <a:ext uri="{FF2B5EF4-FFF2-40B4-BE49-F238E27FC236}">
                <a16:creationId xmlns:a16="http://schemas.microsoft.com/office/drawing/2014/main" id="{2A249AE3-BE72-6342-BD9B-3FBD63878B9E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008116" y="4211604"/>
            <a:ext cx="88900" cy="101600"/>
          </a:xfrm>
          <a:prstGeom prst="rect">
            <a:avLst/>
          </a:prstGeom>
        </p:spPr>
      </p:pic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661E5A06-6B97-A245-972E-51321BA755B8}"/>
              </a:ext>
            </a:extLst>
          </p:cNvPr>
          <p:cNvGrpSpPr/>
          <p:nvPr/>
        </p:nvGrpSpPr>
        <p:grpSpPr>
          <a:xfrm>
            <a:off x="176719" y="2739882"/>
            <a:ext cx="3230134" cy="1928752"/>
            <a:chOff x="190846" y="636152"/>
            <a:chExt cx="3230134" cy="1928752"/>
          </a:xfrm>
        </p:grpSpPr>
        <p:pic>
          <p:nvPicPr>
            <p:cNvPr id="11" name="図 10">
              <a:extLst>
                <a:ext uri="{FF2B5EF4-FFF2-40B4-BE49-F238E27FC236}">
                  <a16:creationId xmlns:a16="http://schemas.microsoft.com/office/drawing/2014/main" id="{9C8F9A3C-9921-614E-A379-D4C470E70A62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237561" y="811318"/>
              <a:ext cx="1615805" cy="1615805"/>
            </a:xfrm>
            <a:prstGeom prst="rect">
              <a:avLst/>
            </a:prstGeom>
          </p:spPr>
        </p:pic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611F31CC-A38D-874E-9C09-AAD21A26C5C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78523" y="2398263"/>
              <a:ext cx="507111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>
                  <a:latin typeface="Times" pitchFamily="2" charset="0"/>
                  <a:ea typeface="HG丸ｺﾞｼｯｸM-PRO" charset="-128"/>
                </a:rPr>
                <a:t>P=0.91</a:t>
              </a: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CAFC4C75-D6B8-E24A-A6F9-CE6AB484196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41979" y="2408275"/>
              <a:ext cx="580433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>
                  <a:latin typeface="Times" pitchFamily="2" charset="0"/>
                  <a:ea typeface="HG丸ｺﾞｼｯｸM-PRO" charset="-128"/>
                </a:rPr>
                <a:t>P=0.87</a:t>
              </a:r>
            </a:p>
          </p:txBody>
        </p:sp>
        <p:pic>
          <p:nvPicPr>
            <p:cNvPr id="31" name="図 30">
              <a:extLst>
                <a:ext uri="{FF2B5EF4-FFF2-40B4-BE49-F238E27FC236}">
                  <a16:creationId xmlns:a16="http://schemas.microsoft.com/office/drawing/2014/main" id="{472F91D9-F8D2-A042-996B-8B4D9D7E6A99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1807312" y="806146"/>
              <a:ext cx="1613668" cy="1613668"/>
            </a:xfrm>
            <a:prstGeom prst="rect">
              <a:avLst/>
            </a:prstGeom>
          </p:spPr>
        </p:pic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34348DD5-4710-464C-8F4C-7989055303C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08584" y="636152"/>
              <a:ext cx="1262787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/>
              <a:r>
                <a:rPr lang="en-US" altLang="ja-JP" sz="1400" dirty="0">
                  <a:latin typeface="Times" pitchFamily="2" charset="0"/>
                  <a:ea typeface="HG丸ｺﾞｼｯｸM-PRO" charset="-128"/>
                </a:rPr>
                <a:t>Pneumonitis</a:t>
              </a: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86993498-C1D1-FD48-8FAA-6B3BC6CA613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87531" y="841788"/>
              <a:ext cx="756133" cy="156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 err="1">
                  <a:latin typeface="Times" pitchFamily="2" charset="0"/>
                  <a:ea typeface="HG丸ｺﾞｼｯｸM-PRO" charset="-128"/>
                </a:rPr>
                <a:t>Osimertinib</a:t>
              </a:r>
              <a:endParaRPr lang="en-US" altLang="ja-JP" sz="1000" dirty="0">
                <a:latin typeface="Times" pitchFamily="2" charset="0"/>
                <a:ea typeface="HG丸ｺﾞｼｯｸM-PRO" charset="-128"/>
              </a:endParaRP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2E31A4D6-11D6-3F40-8FDC-55FD23987A6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72824" y="837649"/>
              <a:ext cx="498569" cy="11597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1000" dirty="0">
                  <a:latin typeface="Times" pitchFamily="2" charset="0"/>
                  <a:ea typeface="HG丸ｺﾞｼｯｸM-PRO" charset="-128"/>
                </a:rPr>
                <a:t>AZ5104</a:t>
              </a:r>
            </a:p>
          </p:txBody>
        </p:sp>
        <p:sp>
          <p:nvSpPr>
            <p:cNvPr id="56" name="正方形/長方形 55">
              <a:extLst>
                <a:ext uri="{FF2B5EF4-FFF2-40B4-BE49-F238E27FC236}">
                  <a16:creationId xmlns:a16="http://schemas.microsoft.com/office/drawing/2014/main" id="{BB4DA39F-E1CC-9C4E-8131-1DD58E32167A}"/>
                </a:ext>
              </a:extLst>
            </p:cNvPr>
            <p:cNvSpPr/>
            <p:nvPr/>
          </p:nvSpPr>
          <p:spPr>
            <a:xfrm>
              <a:off x="369557" y="2196125"/>
              <a:ext cx="137002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" altLang="ja-JP" sz="800" dirty="0">
                  <a:latin typeface="Times" pitchFamily="2" charset="0"/>
                </a:rPr>
                <a:t>Non-occurrence   </a:t>
              </a:r>
              <a:r>
                <a:rPr lang="en" altLang="ja-JP" sz="800" dirty="0" err="1">
                  <a:latin typeface="Times" pitchFamily="2" charset="0"/>
                </a:rPr>
                <a:t>Occurence</a:t>
              </a:r>
              <a:endParaRPr lang="ja-JP" altLang="en-US" sz="800">
                <a:latin typeface="Times" pitchFamily="2" charset="0"/>
              </a:endParaRPr>
            </a:p>
          </p:txBody>
        </p:sp>
        <p:cxnSp>
          <p:nvCxnSpPr>
            <p:cNvPr id="50" name="直線コネクタ 49">
              <a:extLst>
                <a:ext uri="{FF2B5EF4-FFF2-40B4-BE49-F238E27FC236}">
                  <a16:creationId xmlns:a16="http://schemas.microsoft.com/office/drawing/2014/main" id="{2F56E00D-1E2A-E746-B94F-93188A8E1473}"/>
                </a:ext>
              </a:extLst>
            </p:cNvPr>
            <p:cNvCxnSpPr>
              <a:cxnSpLocks/>
            </p:cNvCxnSpPr>
            <p:nvPr/>
          </p:nvCxnSpPr>
          <p:spPr>
            <a:xfrm>
              <a:off x="416496" y="837737"/>
              <a:ext cx="28188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正方形/長方形 58">
              <a:extLst>
                <a:ext uri="{FF2B5EF4-FFF2-40B4-BE49-F238E27FC236}">
                  <a16:creationId xmlns:a16="http://schemas.microsoft.com/office/drawing/2014/main" id="{814D2022-B10C-3843-925D-030F2E047269}"/>
                </a:ext>
              </a:extLst>
            </p:cNvPr>
            <p:cNvSpPr/>
            <p:nvPr/>
          </p:nvSpPr>
          <p:spPr>
            <a:xfrm>
              <a:off x="1807312" y="1537683"/>
              <a:ext cx="80079" cy="1074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" pitchFamily="2" charset="0"/>
              </a:endParaRPr>
            </a:p>
          </p:txBody>
        </p:sp>
        <p:sp>
          <p:nvSpPr>
            <p:cNvPr id="62" name="正方形/長方形 61">
              <a:extLst>
                <a:ext uri="{FF2B5EF4-FFF2-40B4-BE49-F238E27FC236}">
                  <a16:creationId xmlns:a16="http://schemas.microsoft.com/office/drawing/2014/main" id="{21ECA1FA-88B4-8E4D-9394-DD07A002E6DF}"/>
                </a:ext>
              </a:extLst>
            </p:cNvPr>
            <p:cNvSpPr/>
            <p:nvPr/>
          </p:nvSpPr>
          <p:spPr>
            <a:xfrm>
              <a:off x="223335" y="1537682"/>
              <a:ext cx="80079" cy="1074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" pitchFamily="2" charset="0"/>
              </a:endParaRP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996FAA18-F0E2-CB46-884E-54D02334A1C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-109976" y="1441031"/>
              <a:ext cx="758274" cy="1566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800" dirty="0">
                  <a:latin typeface="Times" pitchFamily="2" charset="0"/>
                  <a:ea typeface="HG丸ｺﾞｼｯｸM-PRO" charset="-128"/>
                </a:rPr>
                <a:t>trough ng/ml</a:t>
              </a: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FF8795A5-B8A7-9F4D-96C2-3300F95C2B0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477490" y="1441030"/>
              <a:ext cx="758276" cy="1566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no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r>
                <a:rPr lang="en-US" altLang="ja-JP" sz="800" dirty="0">
                  <a:latin typeface="Times" pitchFamily="2" charset="0"/>
                  <a:ea typeface="HG丸ｺﾞｼｯｸM-PRO" charset="-128"/>
                </a:rPr>
                <a:t>trough ng/ml</a:t>
              </a:r>
            </a:p>
          </p:txBody>
        </p:sp>
        <p:sp>
          <p:nvSpPr>
            <p:cNvPr id="63" name="正方形/長方形 62">
              <a:extLst>
                <a:ext uri="{FF2B5EF4-FFF2-40B4-BE49-F238E27FC236}">
                  <a16:creationId xmlns:a16="http://schemas.microsoft.com/office/drawing/2014/main" id="{1FA64205-B319-154B-A8C3-9696CFAA5809}"/>
                </a:ext>
              </a:extLst>
            </p:cNvPr>
            <p:cNvSpPr/>
            <p:nvPr/>
          </p:nvSpPr>
          <p:spPr>
            <a:xfrm>
              <a:off x="1926789" y="2192831"/>
              <a:ext cx="137002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" altLang="ja-JP" sz="800" dirty="0">
                  <a:latin typeface="Times" pitchFamily="2" charset="0"/>
                </a:rPr>
                <a:t>Non-occurrence   </a:t>
              </a:r>
              <a:r>
                <a:rPr lang="en" altLang="ja-JP" sz="800" dirty="0" err="1">
                  <a:latin typeface="Times" pitchFamily="2" charset="0"/>
                </a:rPr>
                <a:t>Occurence</a:t>
              </a:r>
              <a:endParaRPr lang="ja-JP" altLang="en-US" sz="800">
                <a:latin typeface="Times" pitchFamily="2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331465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D81BA6E-7A24-CC4C-8A6C-05559764247A}"/>
              </a:ext>
            </a:extLst>
          </p:cNvPr>
          <p:cNvSpPr txBox="1"/>
          <p:nvPr/>
        </p:nvSpPr>
        <p:spPr>
          <a:xfrm>
            <a:off x="632520" y="404664"/>
            <a:ext cx="835292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" pitchFamily="2" charset="0"/>
              </a:rPr>
              <a:t>Supplementary Figure </a:t>
            </a:r>
            <a:r>
              <a:rPr lang="en-US" altLang="ja-JP" sz="1400" dirty="0">
                <a:latin typeface="Times" pitchFamily="2" charset="0"/>
              </a:rPr>
              <a:t>3. Comparison of trough levels eight days after the start of </a:t>
            </a:r>
            <a:r>
              <a:rPr lang="en-US" altLang="ja-JP" sz="1400" dirty="0" err="1">
                <a:latin typeface="Times" pitchFamily="2" charset="0"/>
              </a:rPr>
              <a:t>osimertinib</a:t>
            </a:r>
            <a:r>
              <a:rPr lang="en-US" altLang="ja-JP" sz="1400" dirty="0">
                <a:latin typeface="Times" pitchFamily="2" charset="0"/>
              </a:rPr>
              <a:t> treatment between the occurrence group and the non-occurrence group of each adverse events. The rest not shown in Fig.3.</a:t>
            </a:r>
            <a:endParaRPr lang="en-US" altLang="ja-JP" sz="1400" dirty="0">
              <a:latin typeface="Times" pitchFamily="2" charset="0"/>
              <a:ea typeface="HGMaruGothicMPRO" panose="020F0600000000000000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5609713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0368D73-AE3E-8940-9754-CC89A75FD97A}"/>
              </a:ext>
            </a:extLst>
          </p:cNvPr>
          <p:cNvSpPr txBox="1"/>
          <p:nvPr/>
        </p:nvSpPr>
        <p:spPr>
          <a:xfrm>
            <a:off x="2603513" y="4699953"/>
            <a:ext cx="1381432" cy="46166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kumimoji="1" lang="en-US" altLang="ja-JP" sz="1600" dirty="0">
                <a:latin typeface="Times" pitchFamily="2" charset="0"/>
                <a:ea typeface="HGMaruGothicMPRO" panose="020F0600000000000000" pitchFamily="34" charset="-128"/>
              </a:rPr>
              <a:t>P1</a:t>
            </a:r>
            <a:endParaRPr kumimoji="1" lang="ja-JP" altLang="en-US" sz="1600">
              <a:latin typeface="Times" pitchFamily="2" charset="0"/>
              <a:ea typeface="HGMaruGothicMPRO" panose="020F0600000000000000" pitchFamily="34" charset="-128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E8EFF10-6CCD-5549-B8EC-19B71756EF04}"/>
              </a:ext>
            </a:extLst>
          </p:cNvPr>
          <p:cNvSpPr txBox="1"/>
          <p:nvPr/>
        </p:nvSpPr>
        <p:spPr>
          <a:xfrm>
            <a:off x="4264017" y="4705677"/>
            <a:ext cx="1193482" cy="46166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kumimoji="1" lang="en-US" altLang="ja-JP" sz="1600" dirty="0">
                <a:latin typeface="Times" pitchFamily="2" charset="0"/>
                <a:ea typeface="HGMaruGothicMPRO" panose="020F0600000000000000" pitchFamily="34" charset="-128"/>
              </a:rPr>
              <a:t>P2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F4A24D5-AE8A-0C43-93C5-82C073F4FB2E}"/>
              </a:ext>
            </a:extLst>
          </p:cNvPr>
          <p:cNvSpPr txBox="1"/>
          <p:nvPr/>
        </p:nvSpPr>
        <p:spPr>
          <a:xfrm>
            <a:off x="6033120" y="4682932"/>
            <a:ext cx="1547442" cy="46166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kumimoji="1" lang="en-US" altLang="ja-JP" sz="1600" dirty="0">
                <a:latin typeface="Times" pitchFamily="2" charset="0"/>
                <a:ea typeface="HGMaruGothicMPRO" panose="020F0600000000000000" pitchFamily="34" charset="-128"/>
              </a:rPr>
              <a:t>P3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298D505-47CA-0A44-8392-E73A4A40429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65678" y="2850835"/>
            <a:ext cx="1903253" cy="4732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no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r>
              <a:rPr lang="en-US" altLang="ja-JP" sz="1600" dirty="0">
                <a:solidFill>
                  <a:schemeClr val="tx1">
                    <a:lumMod val="75000"/>
                    <a:lumOff val="25000"/>
                  </a:schemeClr>
                </a:solidFill>
                <a:latin typeface="Times" pitchFamily="2" charset="0"/>
                <a:ea typeface="HG丸ｺﾞｼｯｸM-PRO" charset="-128"/>
              </a:rPr>
              <a:t>Osimertinib (ng/ml)</a:t>
            </a:r>
          </a:p>
        </p:txBody>
      </p:sp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F38DD94B-F747-0A43-9891-6B3A8F0DF25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07732093"/>
              </p:ext>
            </p:extLst>
          </p:nvPr>
        </p:nvGraphicFramePr>
        <p:xfrm>
          <a:off x="1319018" y="1340768"/>
          <a:ext cx="7610494" cy="34933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226A7E4-DAF0-6D42-8E3B-630C0BC51104}"/>
              </a:ext>
            </a:extLst>
          </p:cNvPr>
          <p:cNvSpPr txBox="1"/>
          <p:nvPr/>
        </p:nvSpPr>
        <p:spPr>
          <a:xfrm>
            <a:off x="7737905" y="4682933"/>
            <a:ext cx="1547442" cy="46166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kumimoji="1" lang="en-US" altLang="ja-JP" sz="1600" dirty="0">
                <a:latin typeface="Times" pitchFamily="2" charset="0"/>
                <a:ea typeface="HGMaruGothicMPRO" panose="020F0600000000000000" pitchFamily="34" charset="-128"/>
              </a:rPr>
              <a:t>P4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8607E15-62F0-B94A-929F-50593ABBCEC4}"/>
              </a:ext>
            </a:extLst>
          </p:cNvPr>
          <p:cNvSpPr txBox="1"/>
          <p:nvPr/>
        </p:nvSpPr>
        <p:spPr>
          <a:xfrm>
            <a:off x="168164" y="91966"/>
            <a:ext cx="254922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Supplementary Figure 4</a:t>
            </a:r>
          </a:p>
          <a:p>
            <a:r>
              <a:rPr lang="en-US" altLang="ja-JP" sz="1400" dirty="0">
                <a:latin typeface="Helvetica" pitchFamily="2" charset="0"/>
              </a:rPr>
              <a:t>Fukuhara et al.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91E9C93-A275-B241-8DE7-99E5207288B1}"/>
              </a:ext>
            </a:extLst>
          </p:cNvPr>
          <p:cNvSpPr txBox="1"/>
          <p:nvPr/>
        </p:nvSpPr>
        <p:spPr>
          <a:xfrm>
            <a:off x="776536" y="5544603"/>
            <a:ext cx="835292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" pitchFamily="2" charset="0"/>
              </a:rPr>
              <a:t>Supplementary Figure 4</a:t>
            </a:r>
            <a:r>
              <a:rPr lang="en-US" altLang="ja-JP" sz="1400" dirty="0">
                <a:latin typeface="Times" pitchFamily="2" charset="0"/>
              </a:rPr>
              <a:t>. Changes in </a:t>
            </a:r>
            <a:r>
              <a:rPr lang="en-US" altLang="ja-JP" sz="1400" dirty="0" err="1">
                <a:latin typeface="Times" pitchFamily="2" charset="0"/>
              </a:rPr>
              <a:t>osimertinib</a:t>
            </a:r>
            <a:r>
              <a:rPr lang="en-US" altLang="ja-JP" sz="1400" dirty="0">
                <a:latin typeface="Times" pitchFamily="2" charset="0"/>
              </a:rPr>
              <a:t> trough concentration in cases where P2 to P4 could be measured.</a:t>
            </a:r>
          </a:p>
          <a:p>
            <a:r>
              <a:rPr lang="en-US" altLang="ja-JP" sz="1400" dirty="0">
                <a:latin typeface="Times" pitchFamily="2" charset="0"/>
                <a:ea typeface="HGMaruGothicMPRO" panose="020F0600000000000000" pitchFamily="34" charset="-128"/>
              </a:rPr>
              <a:t>P1, Plasma samples taken 8 days from the start of study treatment; P2, Plasma samples taken at the time of adverse events; P3, Plasma samples taken on the 8th day after resumption of treatment after AE; P4, Plasma samples taken at the disease progression.</a:t>
            </a:r>
          </a:p>
        </p:txBody>
      </p:sp>
    </p:spTree>
    <p:extLst>
      <p:ext uri="{BB962C8B-B14F-4D97-AF65-F5344CB8AC3E}">
        <p14:creationId xmlns:p14="http://schemas.microsoft.com/office/powerpoint/2010/main" val="6443790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89</TotalTime>
  <Words>465</Words>
  <Application>Microsoft Macintosh PowerPoint</Application>
  <PresentationFormat>A4 210 x 297 mm</PresentationFormat>
  <Paragraphs>126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2" baseType="lpstr">
      <vt:lpstr>Times</vt:lpstr>
      <vt:lpstr>游ゴシック</vt:lpstr>
      <vt:lpstr>Arial</vt:lpstr>
      <vt:lpstr>Calibri</vt:lpstr>
      <vt:lpstr>Calibri Light</vt:lpstr>
      <vt:lpstr>Helvetica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tsuro Fukuhara</dc:creator>
  <cp:lastModifiedBy>達朗 福原</cp:lastModifiedBy>
  <cp:revision>67</cp:revision>
  <dcterms:created xsi:type="dcterms:W3CDTF">2021-04-22T14:15:03Z</dcterms:created>
  <dcterms:modified xsi:type="dcterms:W3CDTF">2023-07-27T22:55:40Z</dcterms:modified>
</cp:coreProperties>
</file>